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66" r:id="rId2"/>
    <p:sldId id="267" r:id="rId3"/>
    <p:sldId id="265" r:id="rId4"/>
  </p:sldIdLst>
  <p:sldSz cx="16256000" cy="1219200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6E7A3"/>
    <a:srgbClr val="58A4C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9741788-D1B3-433C-B7D5-AEA2313B63CA}" v="30" dt="2025-10-08T13:05:05.588"/>
    <p1510:client id="{3A6CF707-C107-48E9-A1D3-BDA4A4E2C8CC}" v="22" dt="2025-10-08T09:53:00.90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7098" autoAdjust="0"/>
  </p:normalViewPr>
  <p:slideViewPr>
    <p:cSldViewPr snapToGrid="0">
      <p:cViewPr>
        <p:scale>
          <a:sx n="50" d="100"/>
          <a:sy n="50" d="100"/>
        </p:scale>
        <p:origin x="2154" y="-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oberto Garcia Swinburn" userId="94c4e30e-2992-46ed-81ff-aee28425d14e" providerId="ADAL" clId="{2C658FE9-065F-44B4-9314-E65D3DDC6BEE}"/>
    <pc:docChg chg="undo custSel delSld modSld sldOrd modMainMaster modNotesMaster">
      <pc:chgData name="Roberto Garcia Swinburn" userId="94c4e30e-2992-46ed-81ff-aee28425d14e" providerId="ADAL" clId="{2C658FE9-065F-44B4-9314-E65D3DDC6BEE}" dt="2025-10-08T13:05:08.648" v="208" actId="1076"/>
      <pc:docMkLst>
        <pc:docMk/>
      </pc:docMkLst>
      <pc:sldChg chg="del">
        <pc:chgData name="Roberto Garcia Swinburn" userId="94c4e30e-2992-46ed-81ff-aee28425d14e" providerId="ADAL" clId="{2C658FE9-065F-44B4-9314-E65D3DDC6BEE}" dt="2025-10-08T11:42:43.238" v="81" actId="47"/>
        <pc:sldMkLst>
          <pc:docMk/>
          <pc:sldMk cId="996998609" sldId="256"/>
        </pc:sldMkLst>
      </pc:sldChg>
      <pc:sldChg chg="del">
        <pc:chgData name="Roberto Garcia Swinburn" userId="94c4e30e-2992-46ed-81ff-aee28425d14e" providerId="ADAL" clId="{2C658FE9-065F-44B4-9314-E65D3DDC6BEE}" dt="2025-10-08T11:42:43.238" v="81" actId="47"/>
        <pc:sldMkLst>
          <pc:docMk/>
          <pc:sldMk cId="806710897" sldId="257"/>
        </pc:sldMkLst>
      </pc:sldChg>
      <pc:sldChg chg="del">
        <pc:chgData name="Roberto Garcia Swinburn" userId="94c4e30e-2992-46ed-81ff-aee28425d14e" providerId="ADAL" clId="{2C658FE9-065F-44B4-9314-E65D3DDC6BEE}" dt="2025-10-08T11:42:43.238" v="81" actId="47"/>
        <pc:sldMkLst>
          <pc:docMk/>
          <pc:sldMk cId="1924860233" sldId="258"/>
        </pc:sldMkLst>
      </pc:sldChg>
      <pc:sldChg chg="modSp del modNotesTx">
        <pc:chgData name="Roberto Garcia Swinburn" userId="94c4e30e-2992-46ed-81ff-aee28425d14e" providerId="ADAL" clId="{2C658FE9-065F-44B4-9314-E65D3DDC6BEE}" dt="2025-10-08T11:42:43.238" v="81" actId="47"/>
        <pc:sldMkLst>
          <pc:docMk/>
          <pc:sldMk cId="2360760650" sldId="259"/>
        </pc:sldMkLst>
        <pc:graphicFrameChg chg="mod">
          <ac:chgData name="Roberto Garcia Swinburn" userId="94c4e30e-2992-46ed-81ff-aee28425d14e" providerId="ADAL" clId="{2C658FE9-065F-44B4-9314-E65D3DDC6BEE}" dt="2025-10-08T09:53:00.901" v="14"/>
          <ac:graphicFrameMkLst>
            <pc:docMk/>
            <pc:sldMk cId="2360760650" sldId="259"/>
            <ac:graphicFrameMk id="91" creationId="{E6A286AE-0EE4-7752-83BD-60C83CC5AD1F}"/>
          </ac:graphicFrameMkLst>
        </pc:graphicFrameChg>
      </pc:sldChg>
      <pc:sldChg chg="del">
        <pc:chgData name="Roberto Garcia Swinburn" userId="94c4e30e-2992-46ed-81ff-aee28425d14e" providerId="ADAL" clId="{2C658FE9-065F-44B4-9314-E65D3DDC6BEE}" dt="2025-10-08T11:42:43.238" v="81" actId="47"/>
        <pc:sldMkLst>
          <pc:docMk/>
          <pc:sldMk cId="3277499420" sldId="260"/>
        </pc:sldMkLst>
      </pc:sldChg>
      <pc:sldChg chg="del">
        <pc:chgData name="Roberto Garcia Swinburn" userId="94c4e30e-2992-46ed-81ff-aee28425d14e" providerId="ADAL" clId="{2C658FE9-065F-44B4-9314-E65D3DDC6BEE}" dt="2025-10-08T11:42:43.238" v="81" actId="47"/>
        <pc:sldMkLst>
          <pc:docMk/>
          <pc:sldMk cId="3011589055" sldId="261"/>
        </pc:sldMkLst>
      </pc:sldChg>
      <pc:sldChg chg="del">
        <pc:chgData name="Roberto Garcia Swinburn" userId="94c4e30e-2992-46ed-81ff-aee28425d14e" providerId="ADAL" clId="{2C658FE9-065F-44B4-9314-E65D3DDC6BEE}" dt="2025-10-08T11:42:43.238" v="81" actId="47"/>
        <pc:sldMkLst>
          <pc:docMk/>
          <pc:sldMk cId="3282804726" sldId="262"/>
        </pc:sldMkLst>
      </pc:sldChg>
      <pc:sldChg chg="del">
        <pc:chgData name="Roberto Garcia Swinburn" userId="94c4e30e-2992-46ed-81ff-aee28425d14e" providerId="ADAL" clId="{2C658FE9-065F-44B4-9314-E65D3DDC6BEE}" dt="2025-10-08T11:42:43.238" v="81" actId="47"/>
        <pc:sldMkLst>
          <pc:docMk/>
          <pc:sldMk cId="3987506753" sldId="263"/>
        </pc:sldMkLst>
      </pc:sldChg>
      <pc:sldChg chg="del">
        <pc:chgData name="Roberto Garcia Swinburn" userId="94c4e30e-2992-46ed-81ff-aee28425d14e" providerId="ADAL" clId="{2C658FE9-065F-44B4-9314-E65D3DDC6BEE}" dt="2025-10-08T11:42:43.238" v="81" actId="47"/>
        <pc:sldMkLst>
          <pc:docMk/>
          <pc:sldMk cId="1730738618" sldId="264"/>
        </pc:sldMkLst>
      </pc:sldChg>
      <pc:sldChg chg="addSp modSp mod ord modNotes modNotesTx">
        <pc:chgData name="Roberto Garcia Swinburn" userId="94c4e30e-2992-46ed-81ff-aee28425d14e" providerId="ADAL" clId="{2C658FE9-065F-44B4-9314-E65D3DDC6BEE}" dt="2025-10-08T13:05:08.648" v="208" actId="1076"/>
        <pc:sldMkLst>
          <pc:docMk/>
          <pc:sldMk cId="1765151782" sldId="265"/>
        </pc:sldMkLst>
        <pc:spChg chg="add mod">
          <ac:chgData name="Roberto Garcia Swinburn" userId="94c4e30e-2992-46ed-81ff-aee28425d14e" providerId="ADAL" clId="{2C658FE9-065F-44B4-9314-E65D3DDC6BEE}" dt="2025-10-08T13:05:08.648" v="208" actId="1076"/>
          <ac:spMkLst>
            <pc:docMk/>
            <pc:sldMk cId="1765151782" sldId="265"/>
            <ac:spMk id="4" creationId="{E530D4C4-8735-0E03-2A8B-DB8DC975482D}"/>
          </ac:spMkLst>
        </pc:spChg>
        <pc:picChg chg="mod">
          <ac:chgData name="Roberto Garcia Swinburn" userId="94c4e30e-2992-46ed-81ff-aee28425d14e" providerId="ADAL" clId="{2C658FE9-065F-44B4-9314-E65D3DDC6BEE}" dt="2025-10-08T13:05:05.587" v="207" actId="1076"/>
          <ac:picMkLst>
            <pc:docMk/>
            <pc:sldMk cId="1765151782" sldId="265"/>
            <ac:picMk id="2" creationId="{D5EE20A4-F748-E6B1-7BD7-02E5EEA0E6A8}"/>
          </ac:picMkLst>
        </pc:picChg>
      </pc:sldChg>
      <pc:sldChg chg="addSp modSp mod modNotes modNotesTx">
        <pc:chgData name="Roberto Garcia Swinburn" userId="94c4e30e-2992-46ed-81ff-aee28425d14e" providerId="ADAL" clId="{2C658FE9-065F-44B4-9314-E65D3DDC6BEE}" dt="2025-10-08T13:04:20.689" v="191" actId="1076"/>
        <pc:sldMkLst>
          <pc:docMk/>
          <pc:sldMk cId="2570865035" sldId="266"/>
        </pc:sldMkLst>
        <pc:spChg chg="add mod">
          <ac:chgData name="Roberto Garcia Swinburn" userId="94c4e30e-2992-46ed-81ff-aee28425d14e" providerId="ADAL" clId="{2C658FE9-065F-44B4-9314-E65D3DDC6BEE}" dt="2025-10-08T13:04:15.750" v="188" actId="1076"/>
          <ac:spMkLst>
            <pc:docMk/>
            <pc:sldMk cId="2570865035" sldId="266"/>
            <ac:spMk id="4" creationId="{45FE8DEB-EB1A-6267-BBAD-348A98023F1C}"/>
          </ac:spMkLst>
        </pc:spChg>
        <pc:spChg chg="mod">
          <ac:chgData name="Roberto Garcia Swinburn" userId="94c4e30e-2992-46ed-81ff-aee28425d14e" providerId="ADAL" clId="{2C658FE9-065F-44B4-9314-E65D3DDC6BEE}" dt="2025-10-08T13:02:30.443" v="171"/>
          <ac:spMkLst>
            <pc:docMk/>
            <pc:sldMk cId="2570865035" sldId="266"/>
            <ac:spMk id="15" creationId="{16FAB757-6165-AA63-E5BA-59EA7BDB1748}"/>
          </ac:spMkLst>
        </pc:spChg>
        <pc:spChg chg="mod">
          <ac:chgData name="Roberto Garcia Swinburn" userId="94c4e30e-2992-46ed-81ff-aee28425d14e" providerId="ADAL" clId="{2C658FE9-065F-44B4-9314-E65D3DDC6BEE}" dt="2025-10-08T13:02:30.443" v="171"/>
          <ac:spMkLst>
            <pc:docMk/>
            <pc:sldMk cId="2570865035" sldId="266"/>
            <ac:spMk id="16" creationId="{15280100-2C5A-6B91-D9FC-DF47BB6F92BE}"/>
          </ac:spMkLst>
        </pc:spChg>
        <pc:spChg chg="mod">
          <ac:chgData name="Roberto Garcia Swinburn" userId="94c4e30e-2992-46ed-81ff-aee28425d14e" providerId="ADAL" clId="{2C658FE9-065F-44B4-9314-E65D3DDC6BEE}" dt="2025-10-08T13:02:30.443" v="171"/>
          <ac:spMkLst>
            <pc:docMk/>
            <pc:sldMk cId="2570865035" sldId="266"/>
            <ac:spMk id="18" creationId="{9203A2BD-A58C-654E-E254-8A36F8B02CAF}"/>
          </ac:spMkLst>
        </pc:spChg>
        <pc:spChg chg="mod">
          <ac:chgData name="Roberto Garcia Swinburn" userId="94c4e30e-2992-46ed-81ff-aee28425d14e" providerId="ADAL" clId="{2C658FE9-065F-44B4-9314-E65D3DDC6BEE}" dt="2025-10-08T13:02:30.443" v="171"/>
          <ac:spMkLst>
            <pc:docMk/>
            <pc:sldMk cId="2570865035" sldId="266"/>
            <ac:spMk id="19" creationId="{CEB3416F-A893-2959-0DFE-6C50957B82F2}"/>
          </ac:spMkLst>
        </pc:spChg>
        <pc:spChg chg="mod">
          <ac:chgData name="Roberto Garcia Swinburn" userId="94c4e30e-2992-46ed-81ff-aee28425d14e" providerId="ADAL" clId="{2C658FE9-065F-44B4-9314-E65D3DDC6BEE}" dt="2025-10-08T13:02:30.443" v="171"/>
          <ac:spMkLst>
            <pc:docMk/>
            <pc:sldMk cId="2570865035" sldId="266"/>
            <ac:spMk id="20" creationId="{BA2E3C41-7F87-55A5-EC51-9CC040611EDB}"/>
          </ac:spMkLst>
        </pc:spChg>
        <pc:grpChg chg="mod">
          <ac:chgData name="Roberto Garcia Swinburn" userId="94c4e30e-2992-46ed-81ff-aee28425d14e" providerId="ADAL" clId="{2C658FE9-065F-44B4-9314-E65D3DDC6BEE}" dt="2025-10-08T13:04:20.689" v="191" actId="1076"/>
          <ac:grpSpMkLst>
            <pc:docMk/>
            <pc:sldMk cId="2570865035" sldId="266"/>
            <ac:grpSpMk id="21" creationId="{09C89CE9-DE2B-515D-3651-BCAC49E6B732}"/>
          </ac:grpSpMkLst>
        </pc:grpChg>
        <pc:picChg chg="mod">
          <ac:chgData name="Roberto Garcia Swinburn" userId="94c4e30e-2992-46ed-81ff-aee28425d14e" providerId="ADAL" clId="{2C658FE9-065F-44B4-9314-E65D3DDC6BEE}" dt="2025-10-08T13:02:30.443" v="171"/>
          <ac:picMkLst>
            <pc:docMk/>
            <pc:sldMk cId="2570865035" sldId="266"/>
            <ac:picMk id="3" creationId="{AD9CC86D-B228-0DEA-183B-3E40F7C52555}"/>
          </ac:picMkLst>
        </pc:picChg>
        <pc:picChg chg="mod">
          <ac:chgData name="Roberto Garcia Swinburn" userId="94c4e30e-2992-46ed-81ff-aee28425d14e" providerId="ADAL" clId="{2C658FE9-065F-44B4-9314-E65D3DDC6BEE}" dt="2025-10-08T13:02:30.443" v="171"/>
          <ac:picMkLst>
            <pc:docMk/>
            <pc:sldMk cId="2570865035" sldId="266"/>
            <ac:picMk id="5" creationId="{36DCA3F4-3AD8-A126-2C54-F4E88311F7A1}"/>
          </ac:picMkLst>
        </pc:picChg>
        <pc:picChg chg="mod">
          <ac:chgData name="Roberto Garcia Swinburn" userId="94c4e30e-2992-46ed-81ff-aee28425d14e" providerId="ADAL" clId="{2C658FE9-065F-44B4-9314-E65D3DDC6BEE}" dt="2025-10-08T13:02:30.443" v="171"/>
          <ac:picMkLst>
            <pc:docMk/>
            <pc:sldMk cId="2570865035" sldId="266"/>
            <ac:picMk id="7" creationId="{60D27401-D20C-B17F-293B-17CCABE4F2DE}"/>
          </ac:picMkLst>
        </pc:picChg>
        <pc:picChg chg="mod">
          <ac:chgData name="Roberto Garcia Swinburn" userId="94c4e30e-2992-46ed-81ff-aee28425d14e" providerId="ADAL" clId="{2C658FE9-065F-44B4-9314-E65D3DDC6BEE}" dt="2025-10-08T13:02:30.443" v="171"/>
          <ac:picMkLst>
            <pc:docMk/>
            <pc:sldMk cId="2570865035" sldId="266"/>
            <ac:picMk id="9" creationId="{5996F27C-8673-7F98-BCFC-E7CE78EFAB81}"/>
          </ac:picMkLst>
        </pc:picChg>
        <pc:picChg chg="mod">
          <ac:chgData name="Roberto Garcia Swinburn" userId="94c4e30e-2992-46ed-81ff-aee28425d14e" providerId="ADAL" clId="{2C658FE9-065F-44B4-9314-E65D3DDC6BEE}" dt="2025-10-08T13:02:30.443" v="171"/>
          <ac:picMkLst>
            <pc:docMk/>
            <pc:sldMk cId="2570865035" sldId="266"/>
            <ac:picMk id="11" creationId="{FF2C388C-72A2-DB89-A99E-1B551AFD3E6D}"/>
          </ac:picMkLst>
        </pc:picChg>
      </pc:sldChg>
      <pc:sldChg chg="addSp delSp modSp mod modNotes modNotesTx">
        <pc:chgData name="Roberto Garcia Swinburn" userId="94c4e30e-2992-46ed-81ff-aee28425d14e" providerId="ADAL" clId="{2C658FE9-065F-44B4-9314-E65D3DDC6BEE}" dt="2025-10-08T13:04:44.804" v="200" actId="14100"/>
        <pc:sldMkLst>
          <pc:docMk/>
          <pc:sldMk cId="450533740" sldId="267"/>
        </pc:sldMkLst>
        <pc:spChg chg="add mod">
          <ac:chgData name="Roberto Garcia Swinburn" userId="94c4e30e-2992-46ed-81ff-aee28425d14e" providerId="ADAL" clId="{2C658FE9-065F-44B4-9314-E65D3DDC6BEE}" dt="2025-10-08T13:04:44.804" v="200" actId="14100"/>
          <ac:spMkLst>
            <pc:docMk/>
            <pc:sldMk cId="450533740" sldId="267"/>
            <ac:spMk id="3" creationId="{6B03A015-6DE2-EE8A-E61D-1D17E7CAD18F}"/>
          </ac:spMkLst>
        </pc:spChg>
        <pc:spChg chg="mod topLvl">
          <ac:chgData name="Roberto Garcia Swinburn" userId="94c4e30e-2992-46ed-81ff-aee28425d14e" providerId="ADAL" clId="{2C658FE9-065F-44B4-9314-E65D3DDC6BEE}" dt="2025-10-08T13:04:39.130" v="197" actId="1076"/>
          <ac:spMkLst>
            <pc:docMk/>
            <pc:sldMk cId="450533740" sldId="267"/>
            <ac:spMk id="8" creationId="{3D50CAD5-D6AD-00AE-E629-5643E822621A}"/>
          </ac:spMkLst>
        </pc:spChg>
        <pc:spChg chg="mod topLvl">
          <ac:chgData name="Roberto Garcia Swinburn" userId="94c4e30e-2992-46ed-81ff-aee28425d14e" providerId="ADAL" clId="{2C658FE9-065F-44B4-9314-E65D3DDC6BEE}" dt="2025-10-08T13:04:39.130" v="197" actId="1076"/>
          <ac:spMkLst>
            <pc:docMk/>
            <pc:sldMk cId="450533740" sldId="267"/>
            <ac:spMk id="11" creationId="{C005A354-4D7D-41BA-7AE4-751B623EAFA4}"/>
          </ac:spMkLst>
        </pc:spChg>
        <pc:spChg chg="mod topLvl">
          <ac:chgData name="Roberto Garcia Swinburn" userId="94c4e30e-2992-46ed-81ff-aee28425d14e" providerId="ADAL" clId="{2C658FE9-065F-44B4-9314-E65D3DDC6BEE}" dt="2025-10-08T13:04:39.130" v="197" actId="1076"/>
          <ac:spMkLst>
            <pc:docMk/>
            <pc:sldMk cId="450533740" sldId="267"/>
            <ac:spMk id="12" creationId="{D6F8FBD3-D51A-683C-5B32-053D15E20F4E}"/>
          </ac:spMkLst>
        </pc:spChg>
        <pc:spChg chg="mod topLvl">
          <ac:chgData name="Roberto Garcia Swinburn" userId="94c4e30e-2992-46ed-81ff-aee28425d14e" providerId="ADAL" clId="{2C658FE9-065F-44B4-9314-E65D3DDC6BEE}" dt="2025-10-08T13:04:39.130" v="197" actId="1076"/>
          <ac:spMkLst>
            <pc:docMk/>
            <pc:sldMk cId="450533740" sldId="267"/>
            <ac:spMk id="15" creationId="{A9579423-7A98-54F0-0F3F-7CD5077C1B3C}"/>
          </ac:spMkLst>
        </pc:spChg>
        <pc:picChg chg="mod topLvl">
          <ac:chgData name="Roberto Garcia Swinburn" userId="94c4e30e-2992-46ed-81ff-aee28425d14e" providerId="ADAL" clId="{2C658FE9-065F-44B4-9314-E65D3DDC6BEE}" dt="2025-10-08T13:04:39.130" v="197" actId="1076"/>
          <ac:picMkLst>
            <pc:docMk/>
            <pc:sldMk cId="450533740" sldId="267"/>
            <ac:picMk id="7" creationId="{F29A0CDB-7CD1-B271-EF8C-1F6D08642FD1}"/>
          </ac:picMkLst>
        </pc:picChg>
        <pc:picChg chg="mod topLvl">
          <ac:chgData name="Roberto Garcia Swinburn" userId="94c4e30e-2992-46ed-81ff-aee28425d14e" providerId="ADAL" clId="{2C658FE9-065F-44B4-9314-E65D3DDC6BEE}" dt="2025-10-08T13:04:39.130" v="197" actId="1076"/>
          <ac:picMkLst>
            <pc:docMk/>
            <pc:sldMk cId="450533740" sldId="267"/>
            <ac:picMk id="10" creationId="{61EC8BAA-41CC-CBA7-D1D8-FD7572EC0244}"/>
          </ac:picMkLst>
        </pc:picChg>
        <pc:picChg chg="mod topLvl">
          <ac:chgData name="Roberto Garcia Swinburn" userId="94c4e30e-2992-46ed-81ff-aee28425d14e" providerId="ADAL" clId="{2C658FE9-065F-44B4-9314-E65D3DDC6BEE}" dt="2025-10-08T13:04:39.130" v="197" actId="1076"/>
          <ac:picMkLst>
            <pc:docMk/>
            <pc:sldMk cId="450533740" sldId="267"/>
            <ac:picMk id="16" creationId="{9A9E25CA-6203-EE4D-2BDE-4B4F38445BBA}"/>
          </ac:picMkLst>
        </pc:picChg>
        <pc:picChg chg="mod topLvl">
          <ac:chgData name="Roberto Garcia Swinburn" userId="94c4e30e-2992-46ed-81ff-aee28425d14e" providerId="ADAL" clId="{2C658FE9-065F-44B4-9314-E65D3DDC6BEE}" dt="2025-10-08T13:04:39.130" v="197" actId="1076"/>
          <ac:picMkLst>
            <pc:docMk/>
            <pc:sldMk cId="450533740" sldId="267"/>
            <ac:picMk id="3073" creationId="{A5AA7777-4A4B-D999-4EDF-75903217BD02}"/>
          </ac:picMkLst>
        </pc:picChg>
        <pc:picChg chg="mod topLvl">
          <ac:chgData name="Roberto Garcia Swinburn" userId="94c4e30e-2992-46ed-81ff-aee28425d14e" providerId="ADAL" clId="{2C658FE9-065F-44B4-9314-E65D3DDC6BEE}" dt="2025-10-08T13:04:39.130" v="197" actId="1076"/>
          <ac:picMkLst>
            <pc:docMk/>
            <pc:sldMk cId="450533740" sldId="267"/>
            <ac:picMk id="3074" creationId="{45C211D4-9961-4105-B2C7-44896FB7C1DD}"/>
          </ac:picMkLst>
        </pc:picChg>
        <pc:picChg chg="mod topLvl">
          <ac:chgData name="Roberto Garcia Swinburn" userId="94c4e30e-2992-46ed-81ff-aee28425d14e" providerId="ADAL" clId="{2C658FE9-065F-44B4-9314-E65D3DDC6BEE}" dt="2025-10-08T13:04:39.130" v="197" actId="1076"/>
          <ac:picMkLst>
            <pc:docMk/>
            <pc:sldMk cId="450533740" sldId="267"/>
            <ac:picMk id="3076" creationId="{C909D0B9-5498-4838-0015-E95B1461AF1C}"/>
          </ac:picMkLst>
        </pc:picChg>
      </pc:sldChg>
      <pc:sldMasterChg chg="modSp modSldLayout">
        <pc:chgData name="Roberto Garcia Swinburn" userId="94c4e30e-2992-46ed-81ff-aee28425d14e" providerId="ADAL" clId="{2C658FE9-065F-44B4-9314-E65D3DDC6BEE}" dt="2025-10-08T13:02:30.443" v="171"/>
        <pc:sldMasterMkLst>
          <pc:docMk/>
          <pc:sldMasterMk cId="2420436434" sldId="2147483660"/>
        </pc:sldMasterMkLst>
        <pc:spChg chg="mod">
          <ac:chgData name="Roberto Garcia Swinburn" userId="94c4e30e-2992-46ed-81ff-aee28425d14e" providerId="ADAL" clId="{2C658FE9-065F-44B4-9314-E65D3DDC6BEE}" dt="2025-10-08T13:02:30.443" v="171"/>
          <ac:spMkLst>
            <pc:docMk/>
            <pc:sldMasterMk cId="2420436434" sldId="2147483660"/>
            <ac:spMk id="2" creationId="{00000000-0000-0000-0000-000000000000}"/>
          </ac:spMkLst>
        </pc:spChg>
        <pc:spChg chg="mod">
          <ac:chgData name="Roberto Garcia Swinburn" userId="94c4e30e-2992-46ed-81ff-aee28425d14e" providerId="ADAL" clId="{2C658FE9-065F-44B4-9314-E65D3DDC6BEE}" dt="2025-10-08T13:02:30.443" v="171"/>
          <ac:spMkLst>
            <pc:docMk/>
            <pc:sldMasterMk cId="2420436434" sldId="2147483660"/>
            <ac:spMk id="3" creationId="{00000000-0000-0000-0000-000000000000}"/>
          </ac:spMkLst>
        </pc:spChg>
        <pc:spChg chg="mod">
          <ac:chgData name="Roberto Garcia Swinburn" userId="94c4e30e-2992-46ed-81ff-aee28425d14e" providerId="ADAL" clId="{2C658FE9-065F-44B4-9314-E65D3DDC6BEE}" dt="2025-10-08T13:02:30.443" v="171"/>
          <ac:spMkLst>
            <pc:docMk/>
            <pc:sldMasterMk cId="2420436434" sldId="2147483660"/>
            <ac:spMk id="4" creationId="{00000000-0000-0000-0000-000000000000}"/>
          </ac:spMkLst>
        </pc:spChg>
        <pc:spChg chg="mod">
          <ac:chgData name="Roberto Garcia Swinburn" userId="94c4e30e-2992-46ed-81ff-aee28425d14e" providerId="ADAL" clId="{2C658FE9-065F-44B4-9314-E65D3DDC6BEE}" dt="2025-10-08T13:02:30.443" v="171"/>
          <ac:spMkLst>
            <pc:docMk/>
            <pc:sldMasterMk cId="2420436434" sldId="2147483660"/>
            <ac:spMk id="5" creationId="{00000000-0000-0000-0000-000000000000}"/>
          </ac:spMkLst>
        </pc:spChg>
        <pc:spChg chg="mod">
          <ac:chgData name="Roberto Garcia Swinburn" userId="94c4e30e-2992-46ed-81ff-aee28425d14e" providerId="ADAL" clId="{2C658FE9-065F-44B4-9314-E65D3DDC6BEE}" dt="2025-10-08T13:02:30.443" v="171"/>
          <ac:spMkLst>
            <pc:docMk/>
            <pc:sldMasterMk cId="2420436434" sldId="2147483660"/>
            <ac:spMk id="6" creationId="{00000000-0000-0000-0000-000000000000}"/>
          </ac:spMkLst>
        </pc:spChg>
        <pc:sldLayoutChg chg="modSp">
          <pc:chgData name="Roberto Garcia Swinburn" userId="94c4e30e-2992-46ed-81ff-aee28425d14e" providerId="ADAL" clId="{2C658FE9-065F-44B4-9314-E65D3DDC6BEE}" dt="2025-10-08T13:02:30.443" v="171"/>
          <pc:sldLayoutMkLst>
            <pc:docMk/>
            <pc:sldMasterMk cId="2420436434" sldId="2147483660"/>
            <pc:sldLayoutMk cId="3951232950" sldId="2147483661"/>
          </pc:sldLayoutMkLst>
          <pc:spChg chg="mod">
            <ac:chgData name="Roberto Garcia Swinburn" userId="94c4e30e-2992-46ed-81ff-aee28425d14e" providerId="ADAL" clId="{2C658FE9-065F-44B4-9314-E65D3DDC6BEE}" dt="2025-10-08T13:02:30.443" v="171"/>
            <ac:spMkLst>
              <pc:docMk/>
              <pc:sldMasterMk cId="2420436434" sldId="2147483660"/>
              <pc:sldLayoutMk cId="3951232950" sldId="2147483661"/>
              <ac:spMk id="2" creationId="{00000000-0000-0000-0000-000000000000}"/>
            </ac:spMkLst>
          </pc:spChg>
          <pc:spChg chg="mod">
            <ac:chgData name="Roberto Garcia Swinburn" userId="94c4e30e-2992-46ed-81ff-aee28425d14e" providerId="ADAL" clId="{2C658FE9-065F-44B4-9314-E65D3DDC6BEE}" dt="2025-10-08T13:02:30.443" v="171"/>
            <ac:spMkLst>
              <pc:docMk/>
              <pc:sldMasterMk cId="2420436434" sldId="2147483660"/>
              <pc:sldLayoutMk cId="3951232950" sldId="2147483661"/>
              <ac:spMk id="3" creationId="{00000000-0000-0000-0000-000000000000}"/>
            </ac:spMkLst>
          </pc:spChg>
        </pc:sldLayoutChg>
        <pc:sldLayoutChg chg="modSp">
          <pc:chgData name="Roberto Garcia Swinburn" userId="94c4e30e-2992-46ed-81ff-aee28425d14e" providerId="ADAL" clId="{2C658FE9-065F-44B4-9314-E65D3DDC6BEE}" dt="2025-10-08T13:02:30.443" v="171"/>
          <pc:sldLayoutMkLst>
            <pc:docMk/>
            <pc:sldMasterMk cId="2420436434" sldId="2147483660"/>
            <pc:sldLayoutMk cId="3600301802" sldId="2147483663"/>
          </pc:sldLayoutMkLst>
          <pc:spChg chg="mod">
            <ac:chgData name="Roberto Garcia Swinburn" userId="94c4e30e-2992-46ed-81ff-aee28425d14e" providerId="ADAL" clId="{2C658FE9-065F-44B4-9314-E65D3DDC6BEE}" dt="2025-10-08T13:02:30.443" v="171"/>
            <ac:spMkLst>
              <pc:docMk/>
              <pc:sldMasterMk cId="2420436434" sldId="2147483660"/>
              <pc:sldLayoutMk cId="3600301802" sldId="2147483663"/>
              <ac:spMk id="2" creationId="{00000000-0000-0000-0000-000000000000}"/>
            </ac:spMkLst>
          </pc:spChg>
          <pc:spChg chg="mod">
            <ac:chgData name="Roberto Garcia Swinburn" userId="94c4e30e-2992-46ed-81ff-aee28425d14e" providerId="ADAL" clId="{2C658FE9-065F-44B4-9314-E65D3DDC6BEE}" dt="2025-10-08T13:02:30.443" v="171"/>
            <ac:spMkLst>
              <pc:docMk/>
              <pc:sldMasterMk cId="2420436434" sldId="2147483660"/>
              <pc:sldLayoutMk cId="3600301802" sldId="2147483663"/>
              <ac:spMk id="3" creationId="{00000000-0000-0000-0000-000000000000}"/>
            </ac:spMkLst>
          </pc:spChg>
        </pc:sldLayoutChg>
        <pc:sldLayoutChg chg="modSp">
          <pc:chgData name="Roberto Garcia Swinburn" userId="94c4e30e-2992-46ed-81ff-aee28425d14e" providerId="ADAL" clId="{2C658FE9-065F-44B4-9314-E65D3DDC6BEE}" dt="2025-10-08T13:02:30.443" v="171"/>
          <pc:sldLayoutMkLst>
            <pc:docMk/>
            <pc:sldMasterMk cId="2420436434" sldId="2147483660"/>
            <pc:sldLayoutMk cId="490149863" sldId="2147483664"/>
          </pc:sldLayoutMkLst>
          <pc:spChg chg="mod">
            <ac:chgData name="Roberto Garcia Swinburn" userId="94c4e30e-2992-46ed-81ff-aee28425d14e" providerId="ADAL" clId="{2C658FE9-065F-44B4-9314-E65D3DDC6BEE}" dt="2025-10-08T13:02:30.443" v="171"/>
            <ac:spMkLst>
              <pc:docMk/>
              <pc:sldMasterMk cId="2420436434" sldId="2147483660"/>
              <pc:sldLayoutMk cId="490149863" sldId="2147483664"/>
              <ac:spMk id="3" creationId="{00000000-0000-0000-0000-000000000000}"/>
            </ac:spMkLst>
          </pc:spChg>
          <pc:spChg chg="mod">
            <ac:chgData name="Roberto Garcia Swinburn" userId="94c4e30e-2992-46ed-81ff-aee28425d14e" providerId="ADAL" clId="{2C658FE9-065F-44B4-9314-E65D3DDC6BEE}" dt="2025-10-08T13:02:30.443" v="171"/>
            <ac:spMkLst>
              <pc:docMk/>
              <pc:sldMasterMk cId="2420436434" sldId="2147483660"/>
              <pc:sldLayoutMk cId="490149863" sldId="2147483664"/>
              <ac:spMk id="4" creationId="{00000000-0000-0000-0000-000000000000}"/>
            </ac:spMkLst>
          </pc:spChg>
        </pc:sldLayoutChg>
        <pc:sldLayoutChg chg="modSp">
          <pc:chgData name="Roberto Garcia Swinburn" userId="94c4e30e-2992-46ed-81ff-aee28425d14e" providerId="ADAL" clId="{2C658FE9-065F-44B4-9314-E65D3DDC6BEE}" dt="2025-10-08T13:02:30.443" v="171"/>
          <pc:sldLayoutMkLst>
            <pc:docMk/>
            <pc:sldMasterMk cId="2420436434" sldId="2147483660"/>
            <pc:sldLayoutMk cId="2852085620" sldId="2147483665"/>
          </pc:sldLayoutMkLst>
          <pc:spChg chg="mod">
            <ac:chgData name="Roberto Garcia Swinburn" userId="94c4e30e-2992-46ed-81ff-aee28425d14e" providerId="ADAL" clId="{2C658FE9-065F-44B4-9314-E65D3DDC6BEE}" dt="2025-10-08T13:02:30.443" v="171"/>
            <ac:spMkLst>
              <pc:docMk/>
              <pc:sldMasterMk cId="2420436434" sldId="2147483660"/>
              <pc:sldLayoutMk cId="2852085620" sldId="2147483665"/>
              <ac:spMk id="2" creationId="{00000000-0000-0000-0000-000000000000}"/>
            </ac:spMkLst>
          </pc:spChg>
          <pc:spChg chg="mod">
            <ac:chgData name="Roberto Garcia Swinburn" userId="94c4e30e-2992-46ed-81ff-aee28425d14e" providerId="ADAL" clId="{2C658FE9-065F-44B4-9314-E65D3DDC6BEE}" dt="2025-10-08T13:02:30.443" v="171"/>
            <ac:spMkLst>
              <pc:docMk/>
              <pc:sldMasterMk cId="2420436434" sldId="2147483660"/>
              <pc:sldLayoutMk cId="2852085620" sldId="2147483665"/>
              <ac:spMk id="3" creationId="{00000000-0000-0000-0000-000000000000}"/>
            </ac:spMkLst>
          </pc:spChg>
          <pc:spChg chg="mod">
            <ac:chgData name="Roberto Garcia Swinburn" userId="94c4e30e-2992-46ed-81ff-aee28425d14e" providerId="ADAL" clId="{2C658FE9-065F-44B4-9314-E65D3DDC6BEE}" dt="2025-10-08T13:02:30.443" v="171"/>
            <ac:spMkLst>
              <pc:docMk/>
              <pc:sldMasterMk cId="2420436434" sldId="2147483660"/>
              <pc:sldLayoutMk cId="2852085620" sldId="2147483665"/>
              <ac:spMk id="4" creationId="{00000000-0000-0000-0000-000000000000}"/>
            </ac:spMkLst>
          </pc:spChg>
          <pc:spChg chg="mod">
            <ac:chgData name="Roberto Garcia Swinburn" userId="94c4e30e-2992-46ed-81ff-aee28425d14e" providerId="ADAL" clId="{2C658FE9-065F-44B4-9314-E65D3DDC6BEE}" dt="2025-10-08T13:02:30.443" v="171"/>
            <ac:spMkLst>
              <pc:docMk/>
              <pc:sldMasterMk cId="2420436434" sldId="2147483660"/>
              <pc:sldLayoutMk cId="2852085620" sldId="2147483665"/>
              <ac:spMk id="5" creationId="{00000000-0000-0000-0000-000000000000}"/>
            </ac:spMkLst>
          </pc:spChg>
          <pc:spChg chg="mod">
            <ac:chgData name="Roberto Garcia Swinburn" userId="94c4e30e-2992-46ed-81ff-aee28425d14e" providerId="ADAL" clId="{2C658FE9-065F-44B4-9314-E65D3DDC6BEE}" dt="2025-10-08T13:02:30.443" v="171"/>
            <ac:spMkLst>
              <pc:docMk/>
              <pc:sldMasterMk cId="2420436434" sldId="2147483660"/>
              <pc:sldLayoutMk cId="2852085620" sldId="2147483665"/>
              <ac:spMk id="6" creationId="{00000000-0000-0000-0000-000000000000}"/>
            </ac:spMkLst>
          </pc:spChg>
        </pc:sldLayoutChg>
        <pc:sldLayoutChg chg="modSp">
          <pc:chgData name="Roberto Garcia Swinburn" userId="94c4e30e-2992-46ed-81ff-aee28425d14e" providerId="ADAL" clId="{2C658FE9-065F-44B4-9314-E65D3DDC6BEE}" dt="2025-10-08T13:02:30.443" v="171"/>
          <pc:sldLayoutMkLst>
            <pc:docMk/>
            <pc:sldMasterMk cId="2420436434" sldId="2147483660"/>
            <pc:sldLayoutMk cId="724145484" sldId="2147483668"/>
          </pc:sldLayoutMkLst>
          <pc:spChg chg="mod">
            <ac:chgData name="Roberto Garcia Swinburn" userId="94c4e30e-2992-46ed-81ff-aee28425d14e" providerId="ADAL" clId="{2C658FE9-065F-44B4-9314-E65D3DDC6BEE}" dt="2025-10-08T13:02:30.443" v="171"/>
            <ac:spMkLst>
              <pc:docMk/>
              <pc:sldMasterMk cId="2420436434" sldId="2147483660"/>
              <pc:sldLayoutMk cId="724145484" sldId="2147483668"/>
              <ac:spMk id="2" creationId="{00000000-0000-0000-0000-000000000000}"/>
            </ac:spMkLst>
          </pc:spChg>
          <pc:spChg chg="mod">
            <ac:chgData name="Roberto Garcia Swinburn" userId="94c4e30e-2992-46ed-81ff-aee28425d14e" providerId="ADAL" clId="{2C658FE9-065F-44B4-9314-E65D3DDC6BEE}" dt="2025-10-08T13:02:30.443" v="171"/>
            <ac:spMkLst>
              <pc:docMk/>
              <pc:sldMasterMk cId="2420436434" sldId="2147483660"/>
              <pc:sldLayoutMk cId="724145484" sldId="2147483668"/>
              <ac:spMk id="3" creationId="{00000000-0000-0000-0000-000000000000}"/>
            </ac:spMkLst>
          </pc:spChg>
          <pc:spChg chg="mod">
            <ac:chgData name="Roberto Garcia Swinburn" userId="94c4e30e-2992-46ed-81ff-aee28425d14e" providerId="ADAL" clId="{2C658FE9-065F-44B4-9314-E65D3DDC6BEE}" dt="2025-10-08T13:02:30.443" v="171"/>
            <ac:spMkLst>
              <pc:docMk/>
              <pc:sldMasterMk cId="2420436434" sldId="2147483660"/>
              <pc:sldLayoutMk cId="724145484" sldId="2147483668"/>
              <ac:spMk id="4" creationId="{00000000-0000-0000-0000-000000000000}"/>
            </ac:spMkLst>
          </pc:spChg>
        </pc:sldLayoutChg>
        <pc:sldLayoutChg chg="modSp">
          <pc:chgData name="Roberto Garcia Swinburn" userId="94c4e30e-2992-46ed-81ff-aee28425d14e" providerId="ADAL" clId="{2C658FE9-065F-44B4-9314-E65D3DDC6BEE}" dt="2025-10-08T13:02:30.443" v="171"/>
          <pc:sldLayoutMkLst>
            <pc:docMk/>
            <pc:sldMasterMk cId="2420436434" sldId="2147483660"/>
            <pc:sldLayoutMk cId="2081191202" sldId="2147483669"/>
          </pc:sldLayoutMkLst>
          <pc:spChg chg="mod">
            <ac:chgData name="Roberto Garcia Swinburn" userId="94c4e30e-2992-46ed-81ff-aee28425d14e" providerId="ADAL" clId="{2C658FE9-065F-44B4-9314-E65D3DDC6BEE}" dt="2025-10-08T13:02:30.443" v="171"/>
            <ac:spMkLst>
              <pc:docMk/>
              <pc:sldMasterMk cId="2420436434" sldId="2147483660"/>
              <pc:sldLayoutMk cId="2081191202" sldId="2147483669"/>
              <ac:spMk id="2" creationId="{00000000-0000-0000-0000-000000000000}"/>
            </ac:spMkLst>
          </pc:spChg>
          <pc:spChg chg="mod">
            <ac:chgData name="Roberto Garcia Swinburn" userId="94c4e30e-2992-46ed-81ff-aee28425d14e" providerId="ADAL" clId="{2C658FE9-065F-44B4-9314-E65D3DDC6BEE}" dt="2025-10-08T13:02:30.443" v="171"/>
            <ac:spMkLst>
              <pc:docMk/>
              <pc:sldMasterMk cId="2420436434" sldId="2147483660"/>
              <pc:sldLayoutMk cId="2081191202" sldId="2147483669"/>
              <ac:spMk id="3" creationId="{00000000-0000-0000-0000-000000000000}"/>
            </ac:spMkLst>
          </pc:spChg>
          <pc:spChg chg="mod">
            <ac:chgData name="Roberto Garcia Swinburn" userId="94c4e30e-2992-46ed-81ff-aee28425d14e" providerId="ADAL" clId="{2C658FE9-065F-44B4-9314-E65D3DDC6BEE}" dt="2025-10-08T13:02:30.443" v="171"/>
            <ac:spMkLst>
              <pc:docMk/>
              <pc:sldMasterMk cId="2420436434" sldId="2147483660"/>
              <pc:sldLayoutMk cId="2081191202" sldId="2147483669"/>
              <ac:spMk id="4" creationId="{00000000-0000-0000-0000-000000000000}"/>
            </ac:spMkLst>
          </pc:spChg>
        </pc:sldLayoutChg>
        <pc:sldLayoutChg chg="modSp">
          <pc:chgData name="Roberto Garcia Swinburn" userId="94c4e30e-2992-46ed-81ff-aee28425d14e" providerId="ADAL" clId="{2C658FE9-065F-44B4-9314-E65D3DDC6BEE}" dt="2025-10-08T13:02:30.443" v="171"/>
          <pc:sldLayoutMkLst>
            <pc:docMk/>
            <pc:sldMasterMk cId="2420436434" sldId="2147483660"/>
            <pc:sldLayoutMk cId="2353212031" sldId="2147483671"/>
          </pc:sldLayoutMkLst>
          <pc:spChg chg="mod">
            <ac:chgData name="Roberto Garcia Swinburn" userId="94c4e30e-2992-46ed-81ff-aee28425d14e" providerId="ADAL" clId="{2C658FE9-065F-44B4-9314-E65D3DDC6BEE}" dt="2025-10-08T13:02:30.443" v="171"/>
            <ac:spMkLst>
              <pc:docMk/>
              <pc:sldMasterMk cId="2420436434" sldId="2147483660"/>
              <pc:sldLayoutMk cId="2353212031" sldId="2147483671"/>
              <ac:spMk id="2" creationId="{00000000-0000-0000-0000-000000000000}"/>
            </ac:spMkLst>
          </pc:spChg>
          <pc:spChg chg="mod">
            <ac:chgData name="Roberto Garcia Swinburn" userId="94c4e30e-2992-46ed-81ff-aee28425d14e" providerId="ADAL" clId="{2C658FE9-065F-44B4-9314-E65D3DDC6BEE}" dt="2025-10-08T13:02:30.443" v="171"/>
            <ac:spMkLst>
              <pc:docMk/>
              <pc:sldMasterMk cId="2420436434" sldId="2147483660"/>
              <pc:sldLayoutMk cId="2353212031" sldId="2147483671"/>
              <ac:spMk id="3" creationId="{00000000-0000-0000-0000-000000000000}"/>
            </ac:spMkLst>
          </pc:spChg>
        </pc:sldLayoutChg>
      </pc:sldMasterChg>
    </pc:docChg>
  </pc:docChgLst>
  <pc:docChgLst>
    <pc:chgData name="Roberto Garcia Swinburn" userId="94c4e30e-2992-46ed-81ff-aee28425d14e" providerId="ADAL" clId="{F859D573-A876-4869-B849-3F97D73287BA}"/>
    <pc:docChg chg="undo redo custSel addSld delSld modSld">
      <pc:chgData name="Roberto Garcia Swinburn" userId="94c4e30e-2992-46ed-81ff-aee28425d14e" providerId="ADAL" clId="{F859D573-A876-4869-B849-3F97D73287BA}" dt="2025-08-06T10:28:53.140" v="7543" actId="20577"/>
      <pc:docMkLst>
        <pc:docMk/>
      </pc:docMkLst>
      <pc:sldChg chg="addSp delSp modSp new mod modNotesTx">
        <pc:chgData name="Roberto Garcia Swinburn" userId="94c4e30e-2992-46ed-81ff-aee28425d14e" providerId="ADAL" clId="{F859D573-A876-4869-B849-3F97D73287BA}" dt="2025-08-04T10:09:07.362" v="619" actId="164"/>
        <pc:sldMkLst>
          <pc:docMk/>
          <pc:sldMk cId="996998609" sldId="256"/>
        </pc:sldMkLst>
      </pc:sldChg>
      <pc:sldChg chg="addSp delSp modSp add mod">
        <pc:chgData name="Roberto Garcia Swinburn" userId="94c4e30e-2992-46ed-81ff-aee28425d14e" providerId="ADAL" clId="{F859D573-A876-4869-B849-3F97D73287BA}" dt="2025-08-04T10:21:04.502" v="719" actId="164"/>
        <pc:sldMkLst>
          <pc:docMk/>
          <pc:sldMk cId="806710897" sldId="257"/>
        </pc:sldMkLst>
      </pc:sldChg>
      <pc:sldChg chg="addSp modSp add del">
        <pc:chgData name="Roberto Garcia Swinburn" userId="94c4e30e-2992-46ed-81ff-aee28425d14e" providerId="ADAL" clId="{F859D573-A876-4869-B849-3F97D73287BA}" dt="2025-08-04T09:12:54.855" v="14" actId="47"/>
        <pc:sldMkLst>
          <pc:docMk/>
          <pc:sldMk cId="3876398440" sldId="257"/>
        </pc:sldMkLst>
      </pc:sldChg>
      <pc:sldChg chg="addSp delSp modSp new mod modNotesTx">
        <pc:chgData name="Roberto Garcia Swinburn" userId="94c4e30e-2992-46ed-81ff-aee28425d14e" providerId="ADAL" clId="{F859D573-A876-4869-B849-3F97D73287BA}" dt="2025-08-04T11:08:38.481" v="1125" actId="20577"/>
        <pc:sldMkLst>
          <pc:docMk/>
          <pc:sldMk cId="1924860233" sldId="258"/>
        </pc:sldMkLst>
      </pc:sldChg>
      <pc:sldChg chg="addSp delSp modSp new mod modNotesTx">
        <pc:chgData name="Roberto Garcia Swinburn" userId="94c4e30e-2992-46ed-81ff-aee28425d14e" providerId="ADAL" clId="{F859D573-A876-4869-B849-3F97D73287BA}" dt="2025-08-05T09:48:54.070" v="5559" actId="20577"/>
        <pc:sldMkLst>
          <pc:docMk/>
          <pc:sldMk cId="2360760650" sldId="259"/>
        </pc:sldMkLst>
      </pc:sldChg>
      <pc:sldChg chg="addSp delSp modSp add mod modNotesTx">
        <pc:chgData name="Roberto Garcia Swinburn" userId="94c4e30e-2992-46ed-81ff-aee28425d14e" providerId="ADAL" clId="{F859D573-A876-4869-B849-3F97D73287BA}" dt="2025-08-04T14:11:55.653" v="2211" actId="20577"/>
        <pc:sldMkLst>
          <pc:docMk/>
          <pc:sldMk cId="3277499420" sldId="260"/>
        </pc:sldMkLst>
      </pc:sldChg>
      <pc:sldChg chg="addSp delSp modSp new mod modNotesTx">
        <pc:chgData name="Roberto Garcia Swinburn" userId="94c4e30e-2992-46ed-81ff-aee28425d14e" providerId="ADAL" clId="{F859D573-A876-4869-B849-3F97D73287BA}" dt="2025-08-04T15:41:23.022" v="5141" actId="164"/>
        <pc:sldMkLst>
          <pc:docMk/>
          <pc:sldMk cId="3011589055" sldId="261"/>
        </pc:sldMkLst>
      </pc:sldChg>
      <pc:sldChg chg="addSp delSp modSp new mod modNotesTx">
        <pc:chgData name="Roberto Garcia Swinburn" userId="94c4e30e-2992-46ed-81ff-aee28425d14e" providerId="ADAL" clId="{F859D573-A876-4869-B849-3F97D73287BA}" dt="2025-08-05T09:29:18.636" v="5557" actId="164"/>
        <pc:sldMkLst>
          <pc:docMk/>
          <pc:sldMk cId="3282804726" sldId="262"/>
        </pc:sldMkLst>
      </pc:sldChg>
      <pc:sldChg chg="addSp delSp modSp new mod modNotesTx">
        <pc:chgData name="Roberto Garcia Swinburn" userId="94c4e30e-2992-46ed-81ff-aee28425d14e" providerId="ADAL" clId="{F859D573-A876-4869-B849-3F97D73287BA}" dt="2025-08-04T15:03:52.879" v="4321" actId="20577"/>
        <pc:sldMkLst>
          <pc:docMk/>
          <pc:sldMk cId="3987506753" sldId="263"/>
        </pc:sldMkLst>
      </pc:sldChg>
      <pc:sldChg chg="addSp delSp modSp new mod modNotesTx">
        <pc:chgData name="Roberto Garcia Swinburn" userId="94c4e30e-2992-46ed-81ff-aee28425d14e" providerId="ADAL" clId="{F859D573-A876-4869-B849-3F97D73287BA}" dt="2025-08-05T17:38:51.953" v="5564" actId="165"/>
        <pc:sldMkLst>
          <pc:docMk/>
          <pc:sldMk cId="1730738618" sldId="264"/>
        </pc:sldMkLst>
      </pc:sldChg>
      <pc:sldChg chg="addSp delSp modSp new mod modNotesTx">
        <pc:chgData name="Roberto Garcia Swinburn" userId="94c4e30e-2992-46ed-81ff-aee28425d14e" providerId="ADAL" clId="{F859D573-A876-4869-B849-3F97D73287BA}" dt="2025-08-05T17:41:12.958" v="5640" actId="478"/>
        <pc:sldMkLst>
          <pc:docMk/>
          <pc:sldMk cId="1765151782" sldId="265"/>
        </pc:sldMkLst>
      </pc:sldChg>
      <pc:sldChg chg="addSp delSp modSp new mod modNotesTx">
        <pc:chgData name="Roberto Garcia Swinburn" userId="94c4e30e-2992-46ed-81ff-aee28425d14e" providerId="ADAL" clId="{F859D573-A876-4869-B849-3F97D73287BA}" dt="2025-08-06T10:28:53.140" v="7543" actId="20577"/>
        <pc:sldMkLst>
          <pc:docMk/>
          <pc:sldMk cId="2570865035" sldId="266"/>
        </pc:sldMkLst>
      </pc:sldChg>
      <pc:sldChg chg="addSp delSp modSp new mod modNotesTx">
        <pc:chgData name="Roberto Garcia Swinburn" userId="94c4e30e-2992-46ed-81ff-aee28425d14e" providerId="ADAL" clId="{F859D573-A876-4869-B849-3F97D73287BA}" dt="2025-08-06T10:28:46.925" v="7540" actId="20577"/>
        <pc:sldMkLst>
          <pc:docMk/>
          <pc:sldMk cId="450533740" sldId="267"/>
        </pc:sldMkLst>
      </pc:sldChg>
    </pc:docChg>
  </pc:docChgLst>
  <pc:docChgLst>
    <pc:chgData name="Roberto Garcia Swinburn" userId="94c4e30e-2992-46ed-81ff-aee28425d14e" providerId="ADAL" clId="{3A6CF707-C107-48E9-A1D3-BDA4A4E2C8CC}"/>
    <pc:docChg chg="modSld">
      <pc:chgData name="Roberto Garcia Swinburn" userId="94c4e30e-2992-46ed-81ff-aee28425d14e" providerId="ADAL" clId="{3A6CF707-C107-48E9-A1D3-BDA4A4E2C8CC}" dt="2025-09-23T19:47:44.525" v="19"/>
      <pc:docMkLst>
        <pc:docMk/>
      </pc:docMkLst>
      <pc:sldChg chg="delSp modSp">
        <pc:chgData name="Roberto Garcia Swinburn" userId="94c4e30e-2992-46ed-81ff-aee28425d14e" providerId="ADAL" clId="{3A6CF707-C107-48E9-A1D3-BDA4A4E2C8CC}" dt="2025-09-22T10:17:21.019" v="16"/>
        <pc:sldMkLst>
          <pc:docMk/>
          <pc:sldMk cId="996998609" sldId="256"/>
        </pc:sldMkLst>
      </pc:sldChg>
      <pc:sldChg chg="delSp modSp">
        <pc:chgData name="Roberto Garcia Swinburn" userId="94c4e30e-2992-46ed-81ff-aee28425d14e" providerId="ADAL" clId="{3A6CF707-C107-48E9-A1D3-BDA4A4E2C8CC}" dt="2025-09-23T19:47:44.525" v="19"/>
        <pc:sldMkLst>
          <pc:docMk/>
          <pc:sldMk cId="2360760650" sldId="259"/>
        </pc:sldMkLst>
      </pc:sldChg>
      <pc:sldChg chg="modSp">
        <pc:chgData name="Roberto Garcia Swinburn" userId="94c4e30e-2992-46ed-81ff-aee28425d14e" providerId="ADAL" clId="{3A6CF707-C107-48E9-A1D3-BDA4A4E2C8CC}" dt="2025-09-11T11:20:47.321" v="9"/>
        <pc:sldMkLst>
          <pc:docMk/>
          <pc:sldMk cId="3011589055" sldId="261"/>
        </pc:sldMkLst>
      </pc:sldChg>
      <pc:sldChg chg="modSp">
        <pc:chgData name="Roberto Garcia Swinburn" userId="94c4e30e-2992-46ed-81ff-aee28425d14e" providerId="ADAL" clId="{3A6CF707-C107-48E9-A1D3-BDA4A4E2C8CC}" dt="2025-09-11T11:24:46.534" v="15"/>
        <pc:sldMkLst>
          <pc:docMk/>
          <pc:sldMk cId="3282804726" sldId="262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D78447-6098-4F3C-B9D6-D04C941D9C2E}" type="datetimeFigureOut">
              <a:rPr lang="en-GB" smtClean="0"/>
              <a:t>08/10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028950" y="857250"/>
            <a:ext cx="308610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E7DA739-5439-42C6-BB0B-3A38B47F53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18331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028950" y="857250"/>
            <a:ext cx="3086100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sv-SE" b="1" dirty="0" err="1"/>
              <a:t>Supplementary</a:t>
            </a:r>
            <a:r>
              <a:rPr lang="sv-SE" b="1" dirty="0"/>
              <a:t> Fig. 1</a:t>
            </a:r>
            <a:r>
              <a:rPr lang="sv-SE" dirty="0"/>
              <a:t>. </a:t>
            </a:r>
            <a:r>
              <a:rPr lang="sv-SE" dirty="0" err="1"/>
              <a:t>Quality</a:t>
            </a:r>
            <a:r>
              <a:rPr lang="sv-SE" dirty="0"/>
              <a:t> </a:t>
            </a:r>
            <a:r>
              <a:rPr lang="sv-SE" dirty="0" err="1"/>
              <a:t>control</a:t>
            </a:r>
            <a:r>
              <a:rPr lang="sv-SE" dirty="0"/>
              <a:t> </a:t>
            </a:r>
            <a:r>
              <a:rPr lang="sv-SE" dirty="0" err="1"/>
              <a:t>metrics</a:t>
            </a:r>
            <a:r>
              <a:rPr lang="sv-SE" dirty="0"/>
              <a:t> for </a:t>
            </a:r>
            <a:r>
              <a:rPr lang="sv-SE" dirty="0" err="1"/>
              <a:t>multiomic</a:t>
            </a:r>
            <a:r>
              <a:rPr lang="sv-SE" dirty="0"/>
              <a:t> data from KOLF2.1J </a:t>
            </a:r>
            <a:r>
              <a:rPr lang="sv-SE" dirty="0" err="1"/>
              <a:t>hIPSC</a:t>
            </a:r>
            <a:r>
              <a:rPr lang="sv-SE" dirty="0"/>
              <a:t> </a:t>
            </a:r>
            <a:r>
              <a:rPr lang="sv-SE" dirty="0" err="1"/>
              <a:t>differentiated</a:t>
            </a:r>
            <a:r>
              <a:rPr lang="sv-SE" dirty="0"/>
              <a:t> </a:t>
            </a:r>
            <a:r>
              <a:rPr lang="sv-SE" dirty="0" err="1"/>
              <a:t>with</a:t>
            </a:r>
            <a:r>
              <a:rPr lang="sv-SE" dirty="0"/>
              <a:t> </a:t>
            </a:r>
            <a:r>
              <a:rPr lang="sv-SE" dirty="0" err="1"/>
              <a:t>first</a:t>
            </a:r>
            <a:r>
              <a:rPr lang="sv-SE" dirty="0"/>
              <a:t> iteration </a:t>
            </a:r>
            <a:r>
              <a:rPr lang="sv-SE" dirty="0" err="1"/>
              <a:t>protocol</a:t>
            </a:r>
            <a:r>
              <a:rPr lang="sv-SE" dirty="0"/>
              <a:t>. Violin </a:t>
            </a:r>
            <a:r>
              <a:rPr lang="sv-SE" dirty="0" err="1"/>
              <a:t>plots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RNA </a:t>
            </a:r>
            <a:r>
              <a:rPr lang="sv-SE" dirty="0" err="1"/>
              <a:t>count</a:t>
            </a:r>
            <a:r>
              <a:rPr lang="sv-SE" dirty="0"/>
              <a:t> or UMIs per cell (</a:t>
            </a:r>
            <a:r>
              <a:rPr lang="sv-SE" dirty="0" err="1"/>
              <a:t>nCount_RNA</a:t>
            </a:r>
            <a:r>
              <a:rPr lang="sv-SE" dirty="0"/>
              <a:t>), ATAC fragment </a:t>
            </a:r>
            <a:r>
              <a:rPr lang="sv-SE" dirty="0" err="1"/>
              <a:t>counts</a:t>
            </a:r>
            <a:r>
              <a:rPr lang="sv-SE" dirty="0"/>
              <a:t> (</a:t>
            </a:r>
            <a:r>
              <a:rPr lang="sv-SE" dirty="0" err="1"/>
              <a:t>nCount_ATAC</a:t>
            </a:r>
            <a:r>
              <a:rPr lang="sv-SE" dirty="0"/>
              <a:t>), </a:t>
            </a:r>
            <a:r>
              <a:rPr lang="sv-SE" dirty="0" err="1"/>
              <a:t>percentage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</a:t>
            </a:r>
            <a:r>
              <a:rPr lang="sv-SE" dirty="0" err="1"/>
              <a:t>mitochondrial</a:t>
            </a:r>
            <a:r>
              <a:rPr lang="sv-SE" dirty="0"/>
              <a:t> genes </a:t>
            </a:r>
            <a:r>
              <a:rPr lang="sv-SE" dirty="0" err="1"/>
              <a:t>expressed</a:t>
            </a:r>
            <a:r>
              <a:rPr lang="sv-SE" dirty="0"/>
              <a:t> (</a:t>
            </a:r>
            <a:r>
              <a:rPr lang="sv-SE" dirty="0" err="1"/>
              <a:t>percent_mito</a:t>
            </a:r>
            <a:r>
              <a:rPr lang="sv-SE" dirty="0"/>
              <a:t>), </a:t>
            </a:r>
            <a:r>
              <a:rPr lang="sv-SE" dirty="0" err="1"/>
              <a:t>enrichment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</a:t>
            </a:r>
            <a:r>
              <a:rPr lang="sv-SE" dirty="0" err="1"/>
              <a:t>reads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</a:t>
            </a:r>
            <a:r>
              <a:rPr lang="sv-SE" dirty="0" err="1"/>
              <a:t>transcriptional</a:t>
            </a:r>
            <a:r>
              <a:rPr lang="sv-SE" dirty="0"/>
              <a:t> start sites (</a:t>
            </a:r>
            <a:r>
              <a:rPr lang="sv-SE" dirty="0" err="1"/>
              <a:t>TSS.enrichment</a:t>
            </a:r>
            <a:r>
              <a:rPr lang="sv-SE" dirty="0"/>
              <a:t>), </a:t>
            </a:r>
            <a:r>
              <a:rPr lang="sv-SE" dirty="0" err="1"/>
              <a:t>nucleosome</a:t>
            </a:r>
            <a:r>
              <a:rPr lang="sv-SE" dirty="0"/>
              <a:t> bonding </a:t>
            </a:r>
            <a:r>
              <a:rPr lang="sv-SE" dirty="0" err="1"/>
              <a:t>patterns</a:t>
            </a:r>
            <a:r>
              <a:rPr lang="sv-SE" dirty="0"/>
              <a:t> (</a:t>
            </a:r>
            <a:r>
              <a:rPr lang="sv-SE" dirty="0" err="1"/>
              <a:t>nucleosome_signal</a:t>
            </a:r>
            <a:r>
              <a:rPr lang="sv-SE" dirty="0"/>
              <a:t>) and read </a:t>
            </a:r>
            <a:r>
              <a:rPr lang="sv-SE" dirty="0" err="1"/>
              <a:t>count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</a:t>
            </a:r>
            <a:r>
              <a:rPr lang="sv-SE" dirty="0" err="1"/>
              <a:t>barcodes</a:t>
            </a:r>
            <a:r>
              <a:rPr lang="sv-SE" dirty="0"/>
              <a:t> (</a:t>
            </a:r>
            <a:r>
              <a:rPr lang="sv-SE" dirty="0" err="1"/>
              <a:t>frequency_count</a:t>
            </a:r>
            <a:r>
              <a:rPr lang="sv-SE" dirty="0"/>
              <a:t>). </a:t>
            </a:r>
            <a:r>
              <a:rPr lang="sv-SE" dirty="0" err="1"/>
              <a:t>Each</a:t>
            </a:r>
            <a:r>
              <a:rPr lang="sv-SE" dirty="0"/>
              <a:t> </a:t>
            </a:r>
            <a:r>
              <a:rPr lang="sv-SE" dirty="0" err="1"/>
              <a:t>dot</a:t>
            </a:r>
            <a:r>
              <a:rPr lang="sv-SE" dirty="0"/>
              <a:t> </a:t>
            </a:r>
            <a:r>
              <a:rPr lang="sv-SE" dirty="0" err="1"/>
              <a:t>represents</a:t>
            </a:r>
            <a:r>
              <a:rPr lang="sv-SE" dirty="0"/>
              <a:t> </a:t>
            </a:r>
            <a:r>
              <a:rPr lang="sv-SE" dirty="0" err="1"/>
              <a:t>each</a:t>
            </a:r>
            <a:r>
              <a:rPr lang="sv-SE" dirty="0"/>
              <a:t> cell, </a:t>
            </a:r>
            <a:r>
              <a:rPr lang="sv-SE" dirty="0" err="1"/>
              <a:t>each</a:t>
            </a:r>
            <a:r>
              <a:rPr lang="sv-SE" dirty="0"/>
              <a:t> color </a:t>
            </a:r>
            <a:r>
              <a:rPr lang="sv-SE" dirty="0" err="1"/>
              <a:t>represents</a:t>
            </a:r>
            <a:r>
              <a:rPr lang="sv-SE" dirty="0"/>
              <a:t> different </a:t>
            </a:r>
            <a:r>
              <a:rPr lang="sv-SE" dirty="0" err="1"/>
              <a:t>stages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</a:t>
            </a:r>
            <a:r>
              <a:rPr lang="sv-SE" dirty="0" err="1"/>
              <a:t>differentiation</a:t>
            </a:r>
            <a:r>
              <a:rPr lang="sv-SE" dirty="0"/>
              <a:t> (</a:t>
            </a:r>
            <a:r>
              <a:rPr lang="sv-SE" dirty="0" err="1"/>
              <a:t>yellow</a:t>
            </a:r>
            <a:r>
              <a:rPr lang="sv-SE" dirty="0"/>
              <a:t>: DIV11, red: DIV16, </a:t>
            </a:r>
            <a:r>
              <a:rPr lang="sv-SE" dirty="0" err="1"/>
              <a:t>blue</a:t>
            </a:r>
            <a:r>
              <a:rPr lang="sv-SE" dirty="0"/>
              <a:t>: DIV28, </a:t>
            </a:r>
            <a:r>
              <a:rPr lang="sv-SE" dirty="0" err="1"/>
              <a:t>purple</a:t>
            </a:r>
            <a:r>
              <a:rPr lang="sv-SE" dirty="0"/>
              <a:t>: D42, cyan: D56). 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data represented is prior to quality control cutoffs.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7DA739-5439-42C6-BB0B-3A38B47F5361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632630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028950" y="857250"/>
            <a:ext cx="3086100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sv-SE" b="1" dirty="0" err="1"/>
              <a:t>Supplementary</a:t>
            </a:r>
            <a:r>
              <a:rPr lang="sv-SE" b="1" dirty="0"/>
              <a:t> Fig. 2</a:t>
            </a:r>
            <a:r>
              <a:rPr lang="sv-SE" dirty="0"/>
              <a:t>. </a:t>
            </a:r>
            <a:r>
              <a:rPr lang="sv-SE" dirty="0" err="1"/>
              <a:t>Quality</a:t>
            </a:r>
            <a:r>
              <a:rPr lang="sv-SE" dirty="0"/>
              <a:t> </a:t>
            </a:r>
            <a:r>
              <a:rPr lang="sv-SE" dirty="0" err="1"/>
              <a:t>control</a:t>
            </a:r>
            <a:r>
              <a:rPr lang="sv-SE" dirty="0"/>
              <a:t> </a:t>
            </a:r>
            <a:r>
              <a:rPr lang="sv-SE" dirty="0" err="1"/>
              <a:t>metrics</a:t>
            </a:r>
            <a:r>
              <a:rPr lang="sv-SE" dirty="0"/>
              <a:t> for </a:t>
            </a:r>
            <a:r>
              <a:rPr lang="sv-SE" dirty="0" err="1"/>
              <a:t>multiomic</a:t>
            </a:r>
            <a:r>
              <a:rPr lang="sv-SE" dirty="0"/>
              <a:t> data from KOLF2.1J </a:t>
            </a:r>
            <a:r>
              <a:rPr lang="sv-SE" dirty="0" err="1"/>
              <a:t>hIPSC</a:t>
            </a:r>
            <a:r>
              <a:rPr lang="sv-SE" dirty="0"/>
              <a:t> </a:t>
            </a:r>
            <a:r>
              <a:rPr lang="sv-SE" dirty="0" err="1"/>
              <a:t>differentiated</a:t>
            </a:r>
            <a:r>
              <a:rPr lang="sv-SE" dirty="0"/>
              <a:t> </a:t>
            </a:r>
            <a:r>
              <a:rPr lang="sv-SE" dirty="0" err="1"/>
              <a:t>with</a:t>
            </a:r>
            <a:r>
              <a:rPr lang="sv-SE" dirty="0"/>
              <a:t> second iteration </a:t>
            </a:r>
            <a:r>
              <a:rPr lang="sv-SE" dirty="0" err="1"/>
              <a:t>protocol</a:t>
            </a:r>
            <a:r>
              <a:rPr lang="sv-SE" dirty="0"/>
              <a:t> </a:t>
            </a:r>
            <a:r>
              <a:rPr lang="sv-SE" i="1" dirty="0"/>
              <a:t>in vitro</a:t>
            </a:r>
            <a:r>
              <a:rPr lang="sv-SE" i="0" dirty="0"/>
              <a:t> and </a:t>
            </a:r>
            <a:r>
              <a:rPr lang="sv-SE" i="1" dirty="0"/>
              <a:t>in </a:t>
            </a:r>
            <a:r>
              <a:rPr lang="sv-SE" i="1" dirty="0" err="1"/>
              <a:t>vivo</a:t>
            </a:r>
            <a:r>
              <a:rPr lang="sv-SE" dirty="0"/>
              <a:t>. </a:t>
            </a:r>
            <a:r>
              <a:rPr lang="sv-SE" b="1" dirty="0"/>
              <a:t>a</a:t>
            </a:r>
            <a:r>
              <a:rPr lang="sv-SE" dirty="0"/>
              <a:t>, Violin </a:t>
            </a:r>
            <a:r>
              <a:rPr lang="sv-SE" dirty="0" err="1"/>
              <a:t>plots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data from </a:t>
            </a:r>
            <a:r>
              <a:rPr lang="sv-SE" i="1" dirty="0"/>
              <a:t>in vitro </a:t>
            </a:r>
            <a:r>
              <a:rPr lang="sv-SE" i="0" dirty="0" err="1"/>
              <a:t>differentiated</a:t>
            </a:r>
            <a:r>
              <a:rPr lang="sv-SE" i="0" dirty="0"/>
              <a:t> </a:t>
            </a:r>
            <a:r>
              <a:rPr lang="sv-SE" i="0" dirty="0" err="1"/>
              <a:t>hIPSC</a:t>
            </a:r>
            <a:r>
              <a:rPr lang="sv-SE" i="0" dirty="0"/>
              <a:t> at DIV14, DIV16 and DIV28. Data </a:t>
            </a:r>
            <a:r>
              <a:rPr lang="sv-SE" i="0" dirty="0" err="1"/>
              <a:t>represented</a:t>
            </a:r>
            <a:r>
              <a:rPr lang="sv-SE" i="0" dirty="0"/>
              <a:t> is </a:t>
            </a:r>
            <a:r>
              <a:rPr lang="sv-SE" dirty="0"/>
              <a:t>RNA </a:t>
            </a:r>
            <a:r>
              <a:rPr lang="sv-SE" dirty="0" err="1"/>
              <a:t>count</a:t>
            </a:r>
            <a:r>
              <a:rPr lang="sv-SE" dirty="0"/>
              <a:t> or UMIs per cell (</a:t>
            </a:r>
            <a:r>
              <a:rPr lang="sv-SE" dirty="0" err="1"/>
              <a:t>nCount_RNA</a:t>
            </a:r>
            <a:r>
              <a:rPr lang="sv-SE" dirty="0"/>
              <a:t>) and </a:t>
            </a:r>
            <a:r>
              <a:rPr lang="sv-SE" dirty="0" err="1"/>
              <a:t>percentage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</a:t>
            </a:r>
            <a:r>
              <a:rPr lang="sv-SE" dirty="0" err="1"/>
              <a:t>mitochondrial</a:t>
            </a:r>
            <a:r>
              <a:rPr lang="sv-SE" dirty="0"/>
              <a:t> genes </a:t>
            </a:r>
            <a:r>
              <a:rPr lang="sv-SE" dirty="0" err="1"/>
              <a:t>expressed</a:t>
            </a:r>
            <a:r>
              <a:rPr lang="sv-SE" dirty="0"/>
              <a:t> (</a:t>
            </a:r>
            <a:r>
              <a:rPr lang="sv-SE" dirty="0" err="1"/>
              <a:t>percent_mito</a:t>
            </a:r>
            <a:r>
              <a:rPr lang="sv-SE" dirty="0"/>
              <a:t>). </a:t>
            </a:r>
            <a:r>
              <a:rPr lang="sv-SE" b="1" dirty="0"/>
              <a:t>b</a:t>
            </a:r>
            <a:r>
              <a:rPr lang="sv-SE" b="0" dirty="0"/>
              <a:t>,</a:t>
            </a:r>
            <a:r>
              <a:rPr lang="sv-SE" dirty="0"/>
              <a:t> </a:t>
            </a:r>
            <a:r>
              <a:rPr lang="sv-SE" dirty="0" err="1"/>
              <a:t>Dot</a:t>
            </a:r>
            <a:r>
              <a:rPr lang="sv-SE" dirty="0"/>
              <a:t> </a:t>
            </a:r>
            <a:r>
              <a:rPr lang="sv-SE" dirty="0" err="1"/>
              <a:t>plot</a:t>
            </a:r>
            <a:r>
              <a:rPr lang="sv-SE" dirty="0"/>
              <a:t> </a:t>
            </a:r>
            <a:r>
              <a:rPr lang="sv-SE" dirty="0" err="1"/>
              <a:t>representing</a:t>
            </a:r>
            <a:r>
              <a:rPr lang="sv-SE" dirty="0"/>
              <a:t> the </a:t>
            </a:r>
            <a:r>
              <a:rPr lang="sv-SE" dirty="0" err="1"/>
              <a:t>ratio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</a:t>
            </a:r>
            <a:r>
              <a:rPr lang="sv-SE" dirty="0" err="1"/>
              <a:t>counts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human genes </a:t>
            </a:r>
            <a:r>
              <a:rPr lang="sv-SE" dirty="0" err="1"/>
              <a:t>against</a:t>
            </a:r>
            <a:r>
              <a:rPr lang="sv-SE" dirty="0"/>
              <a:t> </a:t>
            </a:r>
            <a:r>
              <a:rPr lang="sv-SE" dirty="0" err="1"/>
              <a:t>mouse</a:t>
            </a:r>
            <a:r>
              <a:rPr lang="sv-SE" dirty="0"/>
              <a:t> genes (</a:t>
            </a:r>
            <a:r>
              <a:rPr lang="sv-SE" dirty="0" err="1"/>
              <a:t>top</a:t>
            </a:r>
            <a:r>
              <a:rPr lang="sv-SE" dirty="0"/>
              <a:t>) and relation </a:t>
            </a:r>
            <a:r>
              <a:rPr lang="sv-SE" dirty="0" err="1"/>
              <a:t>of</a:t>
            </a:r>
            <a:r>
              <a:rPr lang="sv-SE" dirty="0"/>
              <a:t> </a:t>
            </a:r>
            <a:r>
              <a:rPr lang="sv-SE" dirty="0" err="1"/>
              <a:t>mouse</a:t>
            </a:r>
            <a:r>
              <a:rPr lang="sv-SE" dirty="0"/>
              <a:t> transcripts </a:t>
            </a:r>
            <a:r>
              <a:rPr lang="sv-SE" dirty="0" err="1"/>
              <a:t>against</a:t>
            </a:r>
            <a:r>
              <a:rPr lang="sv-SE" dirty="0"/>
              <a:t> human transcripts (</a:t>
            </a:r>
            <a:r>
              <a:rPr lang="sv-SE" dirty="0" err="1"/>
              <a:t>bottom</a:t>
            </a:r>
            <a:r>
              <a:rPr lang="sv-SE" dirty="0"/>
              <a:t>) and </a:t>
            </a:r>
            <a:r>
              <a:rPr lang="sv-SE" dirty="0" err="1"/>
              <a:t>ratio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 from data </a:t>
            </a:r>
            <a:r>
              <a:rPr lang="sv-SE" dirty="0" err="1"/>
              <a:t>extracted</a:t>
            </a:r>
            <a:r>
              <a:rPr lang="sv-SE" dirty="0"/>
              <a:t> from </a:t>
            </a:r>
            <a:r>
              <a:rPr lang="sv-SE" i="1" dirty="0"/>
              <a:t>in </a:t>
            </a:r>
            <a:r>
              <a:rPr lang="sv-SE" i="1" dirty="0" err="1"/>
              <a:t>vivo</a:t>
            </a:r>
            <a:r>
              <a:rPr lang="sv-SE" i="1" dirty="0"/>
              <a:t> </a:t>
            </a:r>
            <a:r>
              <a:rPr lang="sv-SE" dirty="0" err="1"/>
              <a:t>grafted</a:t>
            </a:r>
            <a:r>
              <a:rPr lang="sv-SE" dirty="0"/>
              <a:t> </a:t>
            </a:r>
            <a:r>
              <a:rPr lang="sv-SE" dirty="0" err="1"/>
              <a:t>hIPSC</a:t>
            </a:r>
            <a:r>
              <a:rPr lang="sv-SE" dirty="0"/>
              <a:t> 5 </a:t>
            </a:r>
            <a:r>
              <a:rPr lang="sv-SE" dirty="0" err="1"/>
              <a:t>months</a:t>
            </a:r>
            <a:r>
              <a:rPr lang="sv-SE" dirty="0"/>
              <a:t> post-</a:t>
            </a:r>
            <a:r>
              <a:rPr lang="sv-SE" dirty="0" err="1"/>
              <a:t>graft</a:t>
            </a:r>
            <a:r>
              <a:rPr lang="sv-SE" dirty="0"/>
              <a:t>. </a:t>
            </a:r>
            <a:r>
              <a:rPr lang="sv-SE" b="1" dirty="0"/>
              <a:t>c</a:t>
            </a:r>
            <a:r>
              <a:rPr lang="sv-SE" dirty="0"/>
              <a:t>, </a:t>
            </a:r>
            <a:r>
              <a:rPr lang="sv-SE" dirty="0" err="1"/>
              <a:t>Dot</a:t>
            </a:r>
            <a:r>
              <a:rPr lang="sv-SE" dirty="0"/>
              <a:t> </a:t>
            </a:r>
            <a:r>
              <a:rPr lang="sv-SE" dirty="0" err="1"/>
              <a:t>plot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relation </a:t>
            </a:r>
            <a:r>
              <a:rPr lang="sv-SE" dirty="0" err="1"/>
              <a:t>between</a:t>
            </a:r>
            <a:r>
              <a:rPr lang="sv-SE" dirty="0"/>
              <a:t> human features (</a:t>
            </a:r>
            <a:r>
              <a:rPr lang="sv-SE" dirty="0" err="1"/>
              <a:t>number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human genes </a:t>
            </a:r>
            <a:r>
              <a:rPr lang="sv-SE" dirty="0" err="1"/>
              <a:t>expressed</a:t>
            </a:r>
            <a:r>
              <a:rPr lang="sv-SE" dirty="0"/>
              <a:t> per cell) and human transcripts (UMI per cell).  </a:t>
            </a:r>
            <a:r>
              <a:rPr lang="sv-SE" b="1" dirty="0"/>
              <a:t>d</a:t>
            </a:r>
            <a:r>
              <a:rPr lang="sv-SE" b="0" dirty="0"/>
              <a:t>,</a:t>
            </a:r>
            <a:r>
              <a:rPr lang="sv-SE" dirty="0"/>
              <a:t> Violin </a:t>
            </a:r>
            <a:r>
              <a:rPr lang="sv-SE" dirty="0" err="1"/>
              <a:t>plots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data from </a:t>
            </a:r>
            <a:r>
              <a:rPr lang="sv-SE" i="1" dirty="0"/>
              <a:t>in </a:t>
            </a:r>
            <a:r>
              <a:rPr lang="sv-SE" i="1" dirty="0" err="1"/>
              <a:t>vivo</a:t>
            </a:r>
            <a:r>
              <a:rPr lang="sv-SE" i="1" dirty="0"/>
              <a:t> </a:t>
            </a:r>
            <a:r>
              <a:rPr lang="sv-SE" i="0" dirty="0"/>
              <a:t>(</a:t>
            </a:r>
            <a:r>
              <a:rPr lang="sv-SE" i="0" dirty="0" err="1"/>
              <a:t>grafted</a:t>
            </a:r>
            <a:r>
              <a:rPr lang="sv-SE" i="0" dirty="0"/>
              <a:t>) </a:t>
            </a:r>
            <a:r>
              <a:rPr lang="sv-SE" i="0" dirty="0" err="1"/>
              <a:t>hIPSC</a:t>
            </a:r>
            <a:r>
              <a:rPr lang="sv-SE" i="0" dirty="0"/>
              <a:t> 5 </a:t>
            </a:r>
            <a:r>
              <a:rPr lang="sv-SE" i="0" dirty="0" err="1"/>
              <a:t>months</a:t>
            </a:r>
            <a:r>
              <a:rPr lang="sv-SE" i="0" dirty="0"/>
              <a:t> post-</a:t>
            </a:r>
            <a:r>
              <a:rPr lang="sv-SE" i="0" dirty="0" err="1"/>
              <a:t>graft</a:t>
            </a:r>
            <a:r>
              <a:rPr lang="sv-SE" i="0" dirty="0"/>
              <a:t>. Data </a:t>
            </a:r>
            <a:r>
              <a:rPr lang="sv-SE" i="0" dirty="0" err="1"/>
              <a:t>represented</a:t>
            </a:r>
            <a:r>
              <a:rPr lang="sv-SE" i="0" dirty="0"/>
              <a:t> is </a:t>
            </a:r>
            <a:r>
              <a:rPr lang="sv-SE" dirty="0"/>
              <a:t>RNA </a:t>
            </a:r>
            <a:r>
              <a:rPr lang="sv-SE" dirty="0" err="1"/>
              <a:t>count</a:t>
            </a:r>
            <a:r>
              <a:rPr lang="sv-SE" dirty="0"/>
              <a:t> or UMIs per cell </a:t>
            </a:r>
            <a:r>
              <a:rPr lang="sv-SE" dirty="0" err="1"/>
              <a:t>of</a:t>
            </a:r>
            <a:r>
              <a:rPr lang="sv-SE" dirty="0"/>
              <a:t> human transcripts (</a:t>
            </a:r>
            <a:r>
              <a:rPr lang="sv-SE" dirty="0" err="1"/>
              <a:t>Human_transcripts</a:t>
            </a:r>
            <a:r>
              <a:rPr lang="sv-SE" dirty="0"/>
              <a:t>) and </a:t>
            </a:r>
            <a:r>
              <a:rPr lang="sv-SE" dirty="0" err="1"/>
              <a:t>percentage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</a:t>
            </a:r>
            <a:r>
              <a:rPr lang="sv-SE" dirty="0" err="1"/>
              <a:t>mitochondrial</a:t>
            </a:r>
            <a:r>
              <a:rPr lang="sv-SE" dirty="0"/>
              <a:t> genes </a:t>
            </a:r>
            <a:r>
              <a:rPr lang="sv-SE" dirty="0" err="1"/>
              <a:t>expressed</a:t>
            </a:r>
            <a:r>
              <a:rPr lang="sv-SE" dirty="0"/>
              <a:t> (</a:t>
            </a:r>
            <a:r>
              <a:rPr lang="sv-SE" dirty="0" err="1"/>
              <a:t>percent_mito</a:t>
            </a:r>
            <a:r>
              <a:rPr lang="sv-SE" dirty="0"/>
              <a:t>). For the </a:t>
            </a:r>
            <a:r>
              <a:rPr lang="sv-SE" i="1" dirty="0"/>
              <a:t>in </a:t>
            </a:r>
            <a:r>
              <a:rPr lang="sv-SE" i="1" dirty="0" err="1"/>
              <a:t>vivo</a:t>
            </a:r>
            <a:r>
              <a:rPr lang="sv-SE" i="0" dirty="0"/>
              <a:t> data, the </a:t>
            </a:r>
            <a:r>
              <a:rPr lang="sv-SE" i="0" dirty="0" err="1"/>
              <a:t>identity</a:t>
            </a:r>
            <a:r>
              <a:rPr lang="sv-SE" i="0" dirty="0"/>
              <a:t> </a:t>
            </a:r>
            <a:r>
              <a:rPr lang="sv-SE" i="0" dirty="0" err="1"/>
              <a:t>number</a:t>
            </a:r>
            <a:r>
              <a:rPr lang="sv-SE" i="0" dirty="0"/>
              <a:t> is from the ID </a:t>
            </a:r>
            <a:r>
              <a:rPr lang="sv-SE" i="0" dirty="0" err="1"/>
              <a:t>of</a:t>
            </a:r>
            <a:r>
              <a:rPr lang="sv-SE" i="0" dirty="0"/>
              <a:t> the animal </a:t>
            </a:r>
            <a:r>
              <a:rPr lang="sv-SE" i="0" dirty="0" err="1"/>
              <a:t>grafted</a:t>
            </a:r>
            <a:r>
              <a:rPr lang="sv-SE" i="0" dirty="0"/>
              <a:t>.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7DA739-5439-42C6-BB0B-3A38B47F5361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904694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028950" y="857250"/>
            <a:ext cx="3086100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sv-SE" b="1" dirty="0" err="1"/>
              <a:t>Supplementary</a:t>
            </a:r>
            <a:r>
              <a:rPr lang="sv-SE" b="1" dirty="0"/>
              <a:t> Fig. 3</a:t>
            </a:r>
            <a:r>
              <a:rPr lang="sv-SE" dirty="0"/>
              <a:t>. </a:t>
            </a:r>
            <a:r>
              <a:rPr lang="sv-SE" dirty="0" err="1"/>
              <a:t>Phase</a:t>
            </a:r>
            <a:r>
              <a:rPr lang="sv-SE" dirty="0"/>
              <a:t> </a:t>
            </a:r>
            <a:r>
              <a:rPr lang="sv-SE" dirty="0" err="1"/>
              <a:t>plots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</a:t>
            </a:r>
            <a:r>
              <a:rPr lang="sv-SE" dirty="0" err="1"/>
              <a:t>top</a:t>
            </a:r>
            <a:r>
              <a:rPr lang="sv-SE" dirty="0"/>
              <a:t> 10 </a:t>
            </a:r>
            <a:r>
              <a:rPr lang="sv-SE" dirty="0" err="1"/>
              <a:t>most</a:t>
            </a:r>
            <a:r>
              <a:rPr lang="sv-SE" dirty="0"/>
              <a:t> </a:t>
            </a:r>
            <a:r>
              <a:rPr lang="sv-SE" dirty="0" err="1"/>
              <a:t>dynamic</a:t>
            </a:r>
            <a:r>
              <a:rPr lang="sv-SE" dirty="0"/>
              <a:t> genes for </a:t>
            </a:r>
            <a:r>
              <a:rPr lang="sv-SE" dirty="0" err="1"/>
              <a:t>scVelo</a:t>
            </a:r>
            <a:r>
              <a:rPr lang="sv-SE" dirty="0"/>
              <a:t>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ach plot shows spliced versus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pliced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ranscript counts per cell representing clusters by color (brown: Immature neuron, orange: DA_ONECUT2, green: DA_SOX6, blue: DA_CALB1) with dynamical model fits overlaid (purple).</a:t>
            </a:r>
            <a:endParaRPr lang="en-GB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7DA739-5439-42C6-BB0B-3A38B47F5361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58339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9200" y="1995312"/>
            <a:ext cx="13817600" cy="4244622"/>
          </a:xfrm>
        </p:spPr>
        <p:txBody>
          <a:bodyPr anchor="b"/>
          <a:lstStyle>
            <a:lvl1pPr algn="ctr">
              <a:defRPr sz="106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6403623"/>
            <a:ext cx="12192000" cy="2943577"/>
          </a:xfrm>
        </p:spPr>
        <p:txBody>
          <a:bodyPr/>
          <a:lstStyle>
            <a:lvl1pPr marL="0" indent="0" algn="ctr">
              <a:buNone/>
              <a:defRPr sz="4267"/>
            </a:lvl1pPr>
            <a:lvl2pPr marL="812810" indent="0" algn="ctr">
              <a:buNone/>
              <a:defRPr sz="3556"/>
            </a:lvl2pPr>
            <a:lvl3pPr marL="1625620" indent="0" algn="ctr">
              <a:buNone/>
              <a:defRPr sz="3200"/>
            </a:lvl3pPr>
            <a:lvl4pPr marL="2438430" indent="0" algn="ctr">
              <a:buNone/>
              <a:defRPr sz="2844"/>
            </a:lvl4pPr>
            <a:lvl5pPr marL="3251241" indent="0" algn="ctr">
              <a:buNone/>
              <a:defRPr sz="2844"/>
            </a:lvl5pPr>
            <a:lvl6pPr marL="4064051" indent="0" algn="ctr">
              <a:buNone/>
              <a:defRPr sz="2844"/>
            </a:lvl6pPr>
            <a:lvl7pPr marL="4876861" indent="0" algn="ctr">
              <a:buNone/>
              <a:defRPr sz="2844"/>
            </a:lvl7pPr>
            <a:lvl8pPr marL="5689671" indent="0" algn="ctr">
              <a:buNone/>
              <a:defRPr sz="2844"/>
            </a:lvl8pPr>
            <a:lvl9pPr marL="6502481" indent="0" algn="ctr">
              <a:buNone/>
              <a:defRPr sz="284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263379-EE45-468A-B9AF-6BDABACCBAE1}" type="datetimeFigureOut">
              <a:rPr lang="en-GB" smtClean="0"/>
              <a:t>08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F571F-7F83-426B-A871-D2D9F7BACB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26803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263379-EE45-468A-B9AF-6BDABACCBAE1}" type="datetimeFigureOut">
              <a:rPr lang="en-GB" smtClean="0"/>
              <a:t>08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F571F-7F83-426B-A871-D2D9F7BACB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94084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1" y="649111"/>
            <a:ext cx="3505200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1" y="649111"/>
            <a:ext cx="10312400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263379-EE45-468A-B9AF-6BDABACCBAE1}" type="datetimeFigureOut">
              <a:rPr lang="en-GB" smtClean="0"/>
              <a:t>08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F571F-7F83-426B-A871-D2D9F7BACB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11796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263379-EE45-468A-B9AF-6BDABACCBAE1}" type="datetimeFigureOut">
              <a:rPr lang="en-GB" smtClean="0"/>
              <a:t>08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F571F-7F83-426B-A871-D2D9F7BACB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39761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4" y="3039537"/>
            <a:ext cx="14020800" cy="5071532"/>
          </a:xfrm>
        </p:spPr>
        <p:txBody>
          <a:bodyPr anchor="b"/>
          <a:lstStyle>
            <a:lvl1pPr>
              <a:defRPr sz="106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4" y="8159048"/>
            <a:ext cx="14020800" cy="2666999"/>
          </a:xfrm>
        </p:spPr>
        <p:txBody>
          <a:bodyPr/>
          <a:lstStyle>
            <a:lvl1pPr marL="0" indent="0">
              <a:buNone/>
              <a:defRPr sz="4267">
                <a:solidFill>
                  <a:schemeClr val="tx1">
                    <a:tint val="82000"/>
                  </a:schemeClr>
                </a:solidFill>
              </a:defRPr>
            </a:lvl1pPr>
            <a:lvl2pPr marL="812810" indent="0">
              <a:buNone/>
              <a:defRPr sz="3556">
                <a:solidFill>
                  <a:schemeClr val="tx1">
                    <a:tint val="82000"/>
                  </a:schemeClr>
                </a:solidFill>
              </a:defRPr>
            </a:lvl2pPr>
            <a:lvl3pPr marL="162562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3pPr>
            <a:lvl4pPr marL="2438430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4pPr>
            <a:lvl5pPr marL="3251241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5pPr>
            <a:lvl6pPr marL="4064051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6pPr>
            <a:lvl7pPr marL="4876861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7pPr>
            <a:lvl8pPr marL="5689671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8pPr>
            <a:lvl9pPr marL="6502481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263379-EE45-468A-B9AF-6BDABACCBAE1}" type="datetimeFigureOut">
              <a:rPr lang="en-GB" smtClean="0"/>
              <a:t>08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F571F-7F83-426B-A871-D2D9F7BACB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85166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3245556"/>
            <a:ext cx="690880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3245556"/>
            <a:ext cx="690880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263379-EE45-468A-B9AF-6BDABACCBAE1}" type="datetimeFigureOut">
              <a:rPr lang="en-GB" smtClean="0"/>
              <a:t>08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F571F-7F83-426B-A871-D2D9F7BACB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71807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649114"/>
            <a:ext cx="14020800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9" y="2988734"/>
            <a:ext cx="6877049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9" y="4453467"/>
            <a:ext cx="6877049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1" y="2988734"/>
            <a:ext cx="6910917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1" y="4453467"/>
            <a:ext cx="6910917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263379-EE45-468A-B9AF-6BDABACCBAE1}" type="datetimeFigureOut">
              <a:rPr lang="en-GB" smtClean="0"/>
              <a:t>08/10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F571F-7F83-426B-A871-D2D9F7BACB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83254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263379-EE45-468A-B9AF-6BDABACCBAE1}" type="datetimeFigureOut">
              <a:rPr lang="en-GB" smtClean="0"/>
              <a:t>08/10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F571F-7F83-426B-A871-D2D9F7BACB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19784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263379-EE45-468A-B9AF-6BDABACCBAE1}" type="datetimeFigureOut">
              <a:rPr lang="en-GB" smtClean="0"/>
              <a:t>08/10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F571F-7F83-426B-A871-D2D9F7BACB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9857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1755425"/>
            <a:ext cx="8229600" cy="8664222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263379-EE45-468A-B9AF-6BDABACCBAE1}" type="datetimeFigureOut">
              <a:rPr lang="en-GB" smtClean="0"/>
              <a:t>08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F571F-7F83-426B-A871-D2D9F7BACB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689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1755425"/>
            <a:ext cx="8229600" cy="8664222"/>
          </a:xfrm>
        </p:spPr>
        <p:txBody>
          <a:bodyPr anchor="t"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263379-EE45-468A-B9AF-6BDABACCBAE1}" type="datetimeFigureOut">
              <a:rPr lang="en-GB" smtClean="0"/>
              <a:t>08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F571F-7F83-426B-A871-D2D9F7BACB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83640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649114"/>
            <a:ext cx="140208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3245556"/>
            <a:ext cx="140208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6263379-EE45-468A-B9AF-6BDABACCBAE1}" type="datetimeFigureOut">
              <a:rPr lang="en-GB" smtClean="0"/>
              <a:t>08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11300181"/>
            <a:ext cx="5486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2CF571F-7F83-426B-A871-D2D9F7BACB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75460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625620" rtl="0" eaLnBrk="1" latinLnBrk="0" hangingPunct="1">
        <a:lnSpc>
          <a:spcPct val="90000"/>
        </a:lnSpc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405" indent="-406405" algn="l" defTabSz="1625620" rtl="0" eaLnBrk="1" latinLnBrk="0" hangingPunct="1">
        <a:lnSpc>
          <a:spcPct val="90000"/>
        </a:lnSpc>
        <a:spcBef>
          <a:spcPts val="1778"/>
        </a:spcBef>
        <a:buFont typeface="Arial" panose="020B0604020202020204" pitchFamily="34" charset="0"/>
        <a:buChar char="•"/>
        <a:defRPr sz="4978" kern="1200">
          <a:solidFill>
            <a:schemeClr val="tx1"/>
          </a:solidFill>
          <a:latin typeface="+mn-lt"/>
          <a:ea typeface="+mn-ea"/>
          <a:cs typeface="+mn-cs"/>
        </a:defRPr>
      </a:lvl1pPr>
      <a:lvl2pPr marL="121921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>
            <a:extLst>
              <a:ext uri="{FF2B5EF4-FFF2-40B4-BE49-F238E27FC236}">
                <a16:creationId xmlns:a16="http://schemas.microsoft.com/office/drawing/2014/main" id="{09C89CE9-DE2B-515D-3651-BCAC49E6B732}"/>
              </a:ext>
            </a:extLst>
          </p:cNvPr>
          <p:cNvGrpSpPr/>
          <p:nvPr/>
        </p:nvGrpSpPr>
        <p:grpSpPr>
          <a:xfrm>
            <a:off x="1733642" y="1009844"/>
            <a:ext cx="11802739" cy="8705656"/>
            <a:chOff x="2220946" y="159890"/>
            <a:chExt cx="7465552" cy="5506565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BD71876F-D2E4-8465-BA21-5FA539810381}"/>
                </a:ext>
              </a:extLst>
            </p:cNvPr>
            <p:cNvGrpSpPr/>
            <p:nvPr/>
          </p:nvGrpSpPr>
          <p:grpSpPr>
            <a:xfrm>
              <a:off x="2473931" y="159890"/>
              <a:ext cx="7212567" cy="5506565"/>
              <a:chOff x="2473931" y="159890"/>
              <a:chExt cx="7212567" cy="5506565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AD9CC86D-B228-0DEA-183B-3E40F7C5255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 l="438" r="174"/>
              <a:stretch>
                <a:fillRect/>
              </a:stretch>
            </p:blipFill>
            <p:spPr>
              <a:xfrm>
                <a:off x="2518068" y="159890"/>
                <a:ext cx="7155864" cy="1088000"/>
              </a:xfrm>
              <a:prstGeom prst="rect">
                <a:avLst/>
              </a:prstGeom>
            </p:spPr>
          </p:pic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36DCA3F4-3AD8-A126-2C54-F4E88311F7A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rcRect l="438" t="12177"/>
              <a:stretch>
                <a:fillRect/>
              </a:stretch>
            </p:blipFill>
            <p:spPr>
              <a:xfrm>
                <a:off x="2518067" y="1268074"/>
                <a:ext cx="7168431" cy="1088000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60D27401-D20C-B17F-293B-17CCABE4F2D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rcRect l="438" t="10692" r="174"/>
              <a:stretch>
                <a:fillRect/>
              </a:stretch>
            </p:blipFill>
            <p:spPr>
              <a:xfrm>
                <a:off x="2518067" y="2376258"/>
                <a:ext cx="7155864" cy="1088000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5996F27C-8673-7F98-BCFC-E7CE78EFAB8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rcRect t="12188"/>
              <a:stretch>
                <a:fillRect/>
              </a:stretch>
            </p:blipFill>
            <p:spPr>
              <a:xfrm>
                <a:off x="2473931" y="3484442"/>
                <a:ext cx="7200000" cy="1088001"/>
              </a:xfrm>
              <a:prstGeom prst="rect">
                <a:avLst/>
              </a:prstGeom>
            </p:spPr>
          </p:pic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FF2C388C-72A2-DB89-A99E-1B551AFD3E6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rcRect t="8460" r="606" b="3288"/>
              <a:stretch>
                <a:fillRect/>
              </a:stretch>
            </p:blipFill>
            <p:spPr>
              <a:xfrm>
                <a:off x="2486499" y="4592628"/>
                <a:ext cx="7156269" cy="1073827"/>
              </a:xfrm>
              <a:prstGeom prst="rect">
                <a:avLst/>
              </a:prstGeom>
            </p:spPr>
          </p:pic>
        </p:grp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6FAB757-6165-AA63-E5BA-59EA7BDB1748}"/>
                </a:ext>
              </a:extLst>
            </p:cNvPr>
            <p:cNvSpPr txBox="1"/>
            <p:nvPr/>
          </p:nvSpPr>
          <p:spPr>
            <a:xfrm rot="16200000">
              <a:off x="2150902" y="592222"/>
              <a:ext cx="363417" cy="2233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335" dirty="0">
                  <a:latin typeface="Arial" panose="020B0604020202020204" pitchFamily="34" charset="0"/>
                  <a:cs typeface="Arial" panose="020B0604020202020204" pitchFamily="34" charset="0"/>
                </a:rPr>
                <a:t>D11</a:t>
              </a:r>
              <a:endParaRPr lang="en-GB" sz="133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5280100-2C5A-6B91-D9FC-DF47BB6F92BE}"/>
                </a:ext>
              </a:extLst>
            </p:cNvPr>
            <p:cNvSpPr txBox="1"/>
            <p:nvPr/>
          </p:nvSpPr>
          <p:spPr>
            <a:xfrm rot="16200000">
              <a:off x="2146141" y="1688376"/>
              <a:ext cx="372939" cy="2233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335" dirty="0">
                  <a:latin typeface="Arial" panose="020B0604020202020204" pitchFamily="34" charset="0"/>
                  <a:cs typeface="Arial" panose="020B0604020202020204" pitchFamily="34" charset="0"/>
                </a:rPr>
                <a:t>D16</a:t>
              </a:r>
              <a:endParaRPr lang="en-GB" sz="133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9203A2BD-A58C-654E-E254-8A36F8B02CAF}"/>
                </a:ext>
              </a:extLst>
            </p:cNvPr>
            <p:cNvSpPr txBox="1"/>
            <p:nvPr/>
          </p:nvSpPr>
          <p:spPr>
            <a:xfrm rot="16200000">
              <a:off x="2146141" y="2784531"/>
              <a:ext cx="372939" cy="2233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335" dirty="0">
                  <a:latin typeface="Arial" panose="020B0604020202020204" pitchFamily="34" charset="0"/>
                  <a:cs typeface="Arial" panose="020B0604020202020204" pitchFamily="34" charset="0"/>
                </a:rPr>
                <a:t>D28</a:t>
              </a:r>
              <a:endParaRPr lang="en-GB" sz="133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CEB3416F-A893-2959-0DFE-6C50957B82F2}"/>
                </a:ext>
              </a:extLst>
            </p:cNvPr>
            <p:cNvSpPr txBox="1"/>
            <p:nvPr/>
          </p:nvSpPr>
          <p:spPr>
            <a:xfrm rot="16200000">
              <a:off x="2146141" y="3880683"/>
              <a:ext cx="372939" cy="2233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335" dirty="0">
                  <a:latin typeface="Arial" panose="020B0604020202020204" pitchFamily="34" charset="0"/>
                  <a:cs typeface="Arial" panose="020B0604020202020204" pitchFamily="34" charset="0"/>
                </a:rPr>
                <a:t>D42</a:t>
              </a:r>
              <a:endParaRPr lang="en-GB" sz="133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A2E3C41-7F87-55A5-EC51-9CC040611EDB}"/>
                </a:ext>
              </a:extLst>
            </p:cNvPr>
            <p:cNvSpPr txBox="1"/>
            <p:nvPr/>
          </p:nvSpPr>
          <p:spPr>
            <a:xfrm rot="16200000">
              <a:off x="2082638" y="4976835"/>
              <a:ext cx="499945" cy="2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335" dirty="0">
                  <a:latin typeface="Arial" panose="020B0604020202020204" pitchFamily="34" charset="0"/>
                  <a:cs typeface="Arial" panose="020B0604020202020204" pitchFamily="34" charset="0"/>
                </a:rPr>
                <a:t>D56</a:t>
              </a:r>
              <a:endParaRPr lang="en-GB" sz="133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45FE8DEB-EB1A-6267-BBAD-348A98023F1C}"/>
              </a:ext>
            </a:extLst>
          </p:cNvPr>
          <p:cNvSpPr txBox="1"/>
          <p:nvPr/>
        </p:nvSpPr>
        <p:spPr>
          <a:xfrm>
            <a:off x="952592" y="9992756"/>
            <a:ext cx="14439808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sv-SE" b="1" dirty="0" err="1"/>
              <a:t>Supplementary</a:t>
            </a:r>
            <a:r>
              <a:rPr lang="sv-SE" b="1" dirty="0"/>
              <a:t> Fig. 1</a:t>
            </a:r>
            <a:r>
              <a:rPr lang="sv-SE" dirty="0"/>
              <a:t>. </a:t>
            </a:r>
            <a:r>
              <a:rPr lang="sv-SE" dirty="0" err="1"/>
              <a:t>Quality</a:t>
            </a:r>
            <a:r>
              <a:rPr lang="sv-SE" dirty="0"/>
              <a:t> </a:t>
            </a:r>
            <a:r>
              <a:rPr lang="sv-SE" dirty="0" err="1"/>
              <a:t>control</a:t>
            </a:r>
            <a:r>
              <a:rPr lang="sv-SE" dirty="0"/>
              <a:t> </a:t>
            </a:r>
            <a:r>
              <a:rPr lang="sv-SE" dirty="0" err="1"/>
              <a:t>metrics</a:t>
            </a:r>
            <a:r>
              <a:rPr lang="sv-SE" dirty="0"/>
              <a:t> for </a:t>
            </a:r>
            <a:r>
              <a:rPr lang="sv-SE" dirty="0" err="1"/>
              <a:t>multiomic</a:t>
            </a:r>
            <a:r>
              <a:rPr lang="sv-SE" dirty="0"/>
              <a:t> data from KOLF2.1J </a:t>
            </a:r>
            <a:r>
              <a:rPr lang="sv-SE" dirty="0" err="1"/>
              <a:t>hIPSC</a:t>
            </a:r>
            <a:r>
              <a:rPr lang="sv-SE" dirty="0"/>
              <a:t> </a:t>
            </a:r>
            <a:r>
              <a:rPr lang="sv-SE" dirty="0" err="1"/>
              <a:t>differentiated</a:t>
            </a:r>
            <a:r>
              <a:rPr lang="sv-SE" dirty="0"/>
              <a:t> </a:t>
            </a:r>
            <a:r>
              <a:rPr lang="sv-SE" dirty="0" err="1"/>
              <a:t>with</a:t>
            </a:r>
            <a:r>
              <a:rPr lang="sv-SE" dirty="0"/>
              <a:t> </a:t>
            </a:r>
            <a:r>
              <a:rPr lang="sv-SE" dirty="0" err="1"/>
              <a:t>first</a:t>
            </a:r>
            <a:r>
              <a:rPr lang="sv-SE" dirty="0"/>
              <a:t> iteration </a:t>
            </a:r>
            <a:r>
              <a:rPr lang="sv-SE" dirty="0" err="1"/>
              <a:t>protocol</a:t>
            </a:r>
            <a:r>
              <a:rPr lang="sv-SE" dirty="0"/>
              <a:t>. Violin </a:t>
            </a:r>
            <a:r>
              <a:rPr lang="sv-SE" dirty="0" err="1"/>
              <a:t>plots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RNA </a:t>
            </a:r>
            <a:r>
              <a:rPr lang="sv-SE" dirty="0" err="1"/>
              <a:t>count</a:t>
            </a:r>
            <a:r>
              <a:rPr lang="sv-SE" dirty="0"/>
              <a:t> or UMIs per cell (</a:t>
            </a:r>
            <a:r>
              <a:rPr lang="sv-SE" dirty="0" err="1"/>
              <a:t>nCount_RNA</a:t>
            </a:r>
            <a:r>
              <a:rPr lang="sv-SE" dirty="0"/>
              <a:t>), ATAC fragment </a:t>
            </a:r>
            <a:r>
              <a:rPr lang="sv-SE" dirty="0" err="1"/>
              <a:t>counts</a:t>
            </a:r>
            <a:r>
              <a:rPr lang="sv-SE" dirty="0"/>
              <a:t> (</a:t>
            </a:r>
            <a:r>
              <a:rPr lang="sv-SE" dirty="0" err="1"/>
              <a:t>nCount_ATAC</a:t>
            </a:r>
            <a:r>
              <a:rPr lang="sv-SE" dirty="0"/>
              <a:t>), </a:t>
            </a:r>
            <a:r>
              <a:rPr lang="sv-SE" dirty="0" err="1"/>
              <a:t>percentage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</a:t>
            </a:r>
            <a:r>
              <a:rPr lang="sv-SE" dirty="0" err="1"/>
              <a:t>mitochondrial</a:t>
            </a:r>
            <a:r>
              <a:rPr lang="sv-SE" dirty="0"/>
              <a:t> genes </a:t>
            </a:r>
            <a:r>
              <a:rPr lang="sv-SE" dirty="0" err="1"/>
              <a:t>expressed</a:t>
            </a:r>
            <a:r>
              <a:rPr lang="sv-SE" dirty="0"/>
              <a:t> (</a:t>
            </a:r>
            <a:r>
              <a:rPr lang="sv-SE" dirty="0" err="1"/>
              <a:t>percent_mito</a:t>
            </a:r>
            <a:r>
              <a:rPr lang="sv-SE" dirty="0"/>
              <a:t>), </a:t>
            </a:r>
            <a:r>
              <a:rPr lang="sv-SE" dirty="0" err="1"/>
              <a:t>enrichment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</a:t>
            </a:r>
            <a:r>
              <a:rPr lang="sv-SE" dirty="0" err="1"/>
              <a:t>reads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</a:t>
            </a:r>
            <a:r>
              <a:rPr lang="sv-SE" dirty="0" err="1"/>
              <a:t>transcriptional</a:t>
            </a:r>
            <a:r>
              <a:rPr lang="sv-SE" dirty="0"/>
              <a:t> start sites (</a:t>
            </a:r>
            <a:r>
              <a:rPr lang="sv-SE" dirty="0" err="1"/>
              <a:t>TSS.enrichment</a:t>
            </a:r>
            <a:r>
              <a:rPr lang="sv-SE" dirty="0"/>
              <a:t>), </a:t>
            </a:r>
            <a:r>
              <a:rPr lang="sv-SE" dirty="0" err="1"/>
              <a:t>nucleosome</a:t>
            </a:r>
            <a:r>
              <a:rPr lang="sv-SE" dirty="0"/>
              <a:t> bonding </a:t>
            </a:r>
            <a:r>
              <a:rPr lang="sv-SE" dirty="0" err="1"/>
              <a:t>patterns</a:t>
            </a:r>
            <a:r>
              <a:rPr lang="sv-SE" dirty="0"/>
              <a:t> (</a:t>
            </a:r>
            <a:r>
              <a:rPr lang="sv-SE" dirty="0" err="1"/>
              <a:t>nucleosome_signal</a:t>
            </a:r>
            <a:r>
              <a:rPr lang="sv-SE" dirty="0"/>
              <a:t>) and read </a:t>
            </a:r>
            <a:r>
              <a:rPr lang="sv-SE" dirty="0" err="1"/>
              <a:t>count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</a:t>
            </a:r>
            <a:r>
              <a:rPr lang="sv-SE" dirty="0" err="1"/>
              <a:t>barcodes</a:t>
            </a:r>
            <a:r>
              <a:rPr lang="sv-SE" dirty="0"/>
              <a:t> (</a:t>
            </a:r>
            <a:r>
              <a:rPr lang="sv-SE" dirty="0" err="1"/>
              <a:t>frequency_count</a:t>
            </a:r>
            <a:r>
              <a:rPr lang="sv-SE" dirty="0"/>
              <a:t>). </a:t>
            </a:r>
            <a:r>
              <a:rPr lang="sv-SE" dirty="0" err="1"/>
              <a:t>Each</a:t>
            </a:r>
            <a:r>
              <a:rPr lang="sv-SE" dirty="0"/>
              <a:t> </a:t>
            </a:r>
            <a:r>
              <a:rPr lang="sv-SE" dirty="0" err="1"/>
              <a:t>dot</a:t>
            </a:r>
            <a:r>
              <a:rPr lang="sv-SE" dirty="0"/>
              <a:t> </a:t>
            </a:r>
            <a:r>
              <a:rPr lang="sv-SE" dirty="0" err="1"/>
              <a:t>represents</a:t>
            </a:r>
            <a:r>
              <a:rPr lang="sv-SE" dirty="0"/>
              <a:t> </a:t>
            </a:r>
            <a:r>
              <a:rPr lang="sv-SE" dirty="0" err="1"/>
              <a:t>each</a:t>
            </a:r>
            <a:r>
              <a:rPr lang="sv-SE" dirty="0"/>
              <a:t> cell, </a:t>
            </a:r>
            <a:r>
              <a:rPr lang="sv-SE" dirty="0" err="1"/>
              <a:t>each</a:t>
            </a:r>
            <a:r>
              <a:rPr lang="sv-SE" dirty="0"/>
              <a:t> color </a:t>
            </a:r>
            <a:r>
              <a:rPr lang="sv-SE" dirty="0" err="1"/>
              <a:t>represents</a:t>
            </a:r>
            <a:r>
              <a:rPr lang="sv-SE" dirty="0"/>
              <a:t> different </a:t>
            </a:r>
            <a:r>
              <a:rPr lang="sv-SE" dirty="0" err="1"/>
              <a:t>stages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</a:t>
            </a:r>
            <a:r>
              <a:rPr lang="sv-SE" dirty="0" err="1"/>
              <a:t>differentiation</a:t>
            </a:r>
            <a:r>
              <a:rPr lang="sv-SE" dirty="0"/>
              <a:t> (</a:t>
            </a:r>
            <a:r>
              <a:rPr lang="sv-SE" dirty="0" err="1"/>
              <a:t>yellow</a:t>
            </a:r>
            <a:r>
              <a:rPr lang="sv-SE" dirty="0"/>
              <a:t>: DIV11, red: DIV16, </a:t>
            </a:r>
            <a:r>
              <a:rPr lang="sv-SE" dirty="0" err="1"/>
              <a:t>blue</a:t>
            </a:r>
            <a:r>
              <a:rPr lang="sv-SE" dirty="0"/>
              <a:t>: DIV28, </a:t>
            </a:r>
            <a:r>
              <a:rPr lang="sv-SE" dirty="0" err="1"/>
              <a:t>purple</a:t>
            </a:r>
            <a:r>
              <a:rPr lang="sv-SE" dirty="0"/>
              <a:t>: D42, cyan: D56). </a:t>
            </a:r>
            <a:r>
              <a:rPr lang="en-GB" sz="18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data represented is prior to quality control cutoffs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708650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>
            <a:extLst>
              <a:ext uri="{FF2B5EF4-FFF2-40B4-BE49-F238E27FC236}">
                <a16:creationId xmlns:a16="http://schemas.microsoft.com/office/drawing/2014/main" id="{33B8F3F8-54B4-9E02-86DC-1010A47D9CED}"/>
              </a:ext>
            </a:extLst>
          </p:cNvPr>
          <p:cNvGrpSpPr/>
          <p:nvPr/>
        </p:nvGrpSpPr>
        <p:grpSpPr>
          <a:xfrm>
            <a:off x="227501" y="1614363"/>
            <a:ext cx="15797822" cy="7529637"/>
            <a:chOff x="1224736" y="466724"/>
            <a:chExt cx="10143932" cy="4834851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F29A0CDB-7CD1-B271-EF8C-1F6D08642FD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563290" y="756195"/>
              <a:ext cx="3300540" cy="4545380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D50CAD5-D6AD-00AE-E629-5643E822621A}"/>
                </a:ext>
              </a:extLst>
            </p:cNvPr>
            <p:cNvSpPr txBox="1"/>
            <p:nvPr/>
          </p:nvSpPr>
          <p:spPr>
            <a:xfrm>
              <a:off x="1224736" y="466724"/>
              <a:ext cx="267141" cy="3463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240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GB" sz="240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61EC8BAA-41CC-CBA7-D1D8-FD7572EC024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alphaModFix/>
            </a:blip>
            <a:stretch>
              <a:fillRect/>
            </a:stretch>
          </p:blipFill>
          <p:spPr>
            <a:xfrm>
              <a:off x="8026312" y="673909"/>
              <a:ext cx="3342356" cy="4608210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005A354-4D7D-41BA-7AE4-751B623EAFA4}"/>
                </a:ext>
              </a:extLst>
            </p:cNvPr>
            <p:cNvSpPr txBox="1"/>
            <p:nvPr/>
          </p:nvSpPr>
          <p:spPr>
            <a:xfrm>
              <a:off x="7622478" y="466724"/>
              <a:ext cx="267141" cy="3463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240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GB" sz="240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073" name="Picture 1">
              <a:extLst>
                <a:ext uri="{FF2B5EF4-FFF2-40B4-BE49-F238E27FC236}">
                  <a16:creationId xmlns:a16="http://schemas.microsoft.com/office/drawing/2014/main" id="{A5AA7777-4A4B-D999-4EDF-75903217BD02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000" r="12920"/>
            <a:stretch>
              <a:fillRect/>
            </a:stretch>
          </p:blipFill>
          <p:spPr bwMode="auto">
            <a:xfrm>
              <a:off x="5569435" y="2172512"/>
              <a:ext cx="1584265" cy="12962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74" name="Picture 2">
              <a:extLst>
                <a:ext uri="{FF2B5EF4-FFF2-40B4-BE49-F238E27FC236}">
                  <a16:creationId xmlns:a16="http://schemas.microsoft.com/office/drawing/2014/main" id="{45C211D4-9961-4105-B2C7-44896FB7C1D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4015"/>
            <a:stretch>
              <a:fillRect/>
            </a:stretch>
          </p:blipFill>
          <p:spPr bwMode="auto">
            <a:xfrm>
              <a:off x="5659354" y="673909"/>
              <a:ext cx="1623253" cy="141589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D6F8FBD3-D51A-683C-5B32-053D15E20F4E}"/>
                </a:ext>
              </a:extLst>
            </p:cNvPr>
            <p:cNvSpPr txBox="1"/>
            <p:nvPr/>
          </p:nvSpPr>
          <p:spPr>
            <a:xfrm>
              <a:off x="4928503" y="466724"/>
              <a:ext cx="267141" cy="3463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240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GB" sz="240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076" name="Picture 4">
              <a:extLst>
                <a:ext uri="{FF2B5EF4-FFF2-40B4-BE49-F238E27FC236}">
                  <a16:creationId xmlns:a16="http://schemas.microsoft.com/office/drawing/2014/main" id="{C909D0B9-5498-4838-0015-E95B1461AF1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438" r="6650"/>
            <a:stretch>
              <a:fillRect/>
            </a:stretch>
          </p:blipFill>
          <p:spPr bwMode="auto">
            <a:xfrm>
              <a:off x="5143743" y="3551483"/>
              <a:ext cx="2875031" cy="156968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9579423-7A98-54F0-0F3F-7CD5077C1B3C}"/>
                </a:ext>
              </a:extLst>
            </p:cNvPr>
            <p:cNvSpPr txBox="1"/>
            <p:nvPr/>
          </p:nvSpPr>
          <p:spPr>
            <a:xfrm>
              <a:off x="4922091" y="3121851"/>
              <a:ext cx="253915" cy="3463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240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GB" sz="240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6" name="Picture 1">
              <a:extLst>
                <a:ext uri="{FF2B5EF4-FFF2-40B4-BE49-F238E27FC236}">
                  <a16:creationId xmlns:a16="http://schemas.microsoft.com/office/drawing/2014/main" id="{9A9E25CA-6203-EE4D-2BDE-4B4F38445BBA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016" t="35484" r="-1517" b="37448"/>
            <a:stretch>
              <a:fillRect/>
            </a:stretch>
          </p:blipFill>
          <p:spPr bwMode="auto">
            <a:xfrm>
              <a:off x="7122143" y="2308791"/>
              <a:ext cx="585294" cy="72009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6B03A015-6DE2-EE8A-E61D-1D17E7CAD18F}"/>
              </a:ext>
            </a:extLst>
          </p:cNvPr>
          <p:cNvSpPr txBox="1"/>
          <p:nvPr/>
        </p:nvSpPr>
        <p:spPr>
          <a:xfrm>
            <a:off x="227500" y="9485040"/>
            <a:ext cx="15797823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sv-SE" b="1" dirty="0" err="1"/>
              <a:t>Supplementary</a:t>
            </a:r>
            <a:r>
              <a:rPr lang="sv-SE" b="1" dirty="0"/>
              <a:t> Fig. 2</a:t>
            </a:r>
            <a:r>
              <a:rPr lang="sv-SE" dirty="0"/>
              <a:t>. </a:t>
            </a:r>
            <a:r>
              <a:rPr lang="sv-SE" dirty="0" err="1"/>
              <a:t>Quality</a:t>
            </a:r>
            <a:r>
              <a:rPr lang="sv-SE" dirty="0"/>
              <a:t> </a:t>
            </a:r>
            <a:r>
              <a:rPr lang="sv-SE" dirty="0" err="1"/>
              <a:t>control</a:t>
            </a:r>
            <a:r>
              <a:rPr lang="sv-SE" dirty="0"/>
              <a:t> </a:t>
            </a:r>
            <a:r>
              <a:rPr lang="sv-SE" dirty="0" err="1"/>
              <a:t>metrics</a:t>
            </a:r>
            <a:r>
              <a:rPr lang="sv-SE" dirty="0"/>
              <a:t> for </a:t>
            </a:r>
            <a:r>
              <a:rPr lang="sv-SE" dirty="0" err="1"/>
              <a:t>multiomic</a:t>
            </a:r>
            <a:r>
              <a:rPr lang="sv-SE" dirty="0"/>
              <a:t> data from KOLF2.1J </a:t>
            </a:r>
            <a:r>
              <a:rPr lang="sv-SE" dirty="0" err="1"/>
              <a:t>hIPSC</a:t>
            </a:r>
            <a:r>
              <a:rPr lang="sv-SE" dirty="0"/>
              <a:t> </a:t>
            </a:r>
            <a:r>
              <a:rPr lang="sv-SE" dirty="0" err="1"/>
              <a:t>differentiated</a:t>
            </a:r>
            <a:r>
              <a:rPr lang="sv-SE" dirty="0"/>
              <a:t> </a:t>
            </a:r>
            <a:r>
              <a:rPr lang="sv-SE" dirty="0" err="1"/>
              <a:t>with</a:t>
            </a:r>
            <a:r>
              <a:rPr lang="sv-SE" dirty="0"/>
              <a:t> second iteration </a:t>
            </a:r>
            <a:r>
              <a:rPr lang="sv-SE" dirty="0" err="1"/>
              <a:t>protocol</a:t>
            </a:r>
            <a:r>
              <a:rPr lang="sv-SE" dirty="0"/>
              <a:t> </a:t>
            </a:r>
            <a:r>
              <a:rPr lang="sv-SE" i="1" dirty="0"/>
              <a:t>in vitro</a:t>
            </a:r>
            <a:r>
              <a:rPr lang="sv-SE" i="0" dirty="0"/>
              <a:t> and </a:t>
            </a:r>
            <a:r>
              <a:rPr lang="sv-SE" i="1" dirty="0"/>
              <a:t>in </a:t>
            </a:r>
            <a:r>
              <a:rPr lang="sv-SE" i="1" dirty="0" err="1"/>
              <a:t>vivo</a:t>
            </a:r>
            <a:r>
              <a:rPr lang="sv-SE" dirty="0"/>
              <a:t>. </a:t>
            </a:r>
            <a:r>
              <a:rPr lang="sv-SE" b="1" dirty="0"/>
              <a:t>a</a:t>
            </a:r>
            <a:r>
              <a:rPr lang="sv-SE" dirty="0"/>
              <a:t>, Violin </a:t>
            </a:r>
            <a:r>
              <a:rPr lang="sv-SE" dirty="0" err="1"/>
              <a:t>plots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data from </a:t>
            </a:r>
            <a:r>
              <a:rPr lang="sv-SE" i="1" dirty="0"/>
              <a:t>in vitro </a:t>
            </a:r>
            <a:r>
              <a:rPr lang="sv-SE" i="0" dirty="0" err="1"/>
              <a:t>differentiated</a:t>
            </a:r>
            <a:r>
              <a:rPr lang="sv-SE" i="0" dirty="0"/>
              <a:t> </a:t>
            </a:r>
            <a:r>
              <a:rPr lang="sv-SE" i="0" dirty="0" err="1"/>
              <a:t>hIPSC</a:t>
            </a:r>
            <a:r>
              <a:rPr lang="sv-SE" i="0" dirty="0"/>
              <a:t> at DIV14, DIV16 and DIV28. Data </a:t>
            </a:r>
            <a:r>
              <a:rPr lang="sv-SE" i="0" dirty="0" err="1"/>
              <a:t>represented</a:t>
            </a:r>
            <a:r>
              <a:rPr lang="sv-SE" i="0" dirty="0"/>
              <a:t> is </a:t>
            </a:r>
            <a:r>
              <a:rPr lang="sv-SE" dirty="0"/>
              <a:t>RNA </a:t>
            </a:r>
            <a:r>
              <a:rPr lang="sv-SE" dirty="0" err="1"/>
              <a:t>count</a:t>
            </a:r>
            <a:r>
              <a:rPr lang="sv-SE" dirty="0"/>
              <a:t> or UMIs per cell (</a:t>
            </a:r>
            <a:r>
              <a:rPr lang="sv-SE" dirty="0" err="1"/>
              <a:t>nCount_RNA</a:t>
            </a:r>
            <a:r>
              <a:rPr lang="sv-SE" dirty="0"/>
              <a:t>) and </a:t>
            </a:r>
            <a:r>
              <a:rPr lang="sv-SE" dirty="0" err="1"/>
              <a:t>percentage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</a:t>
            </a:r>
            <a:r>
              <a:rPr lang="sv-SE" dirty="0" err="1"/>
              <a:t>mitochondrial</a:t>
            </a:r>
            <a:r>
              <a:rPr lang="sv-SE" dirty="0"/>
              <a:t> genes </a:t>
            </a:r>
            <a:r>
              <a:rPr lang="sv-SE" dirty="0" err="1"/>
              <a:t>expressed</a:t>
            </a:r>
            <a:r>
              <a:rPr lang="sv-SE" dirty="0"/>
              <a:t> (</a:t>
            </a:r>
            <a:r>
              <a:rPr lang="sv-SE" dirty="0" err="1"/>
              <a:t>percent_mito</a:t>
            </a:r>
            <a:r>
              <a:rPr lang="sv-SE" dirty="0"/>
              <a:t>). </a:t>
            </a:r>
            <a:r>
              <a:rPr lang="sv-SE" b="1" dirty="0"/>
              <a:t>b</a:t>
            </a:r>
            <a:r>
              <a:rPr lang="sv-SE" b="0" dirty="0"/>
              <a:t>,</a:t>
            </a:r>
            <a:r>
              <a:rPr lang="sv-SE" dirty="0"/>
              <a:t> </a:t>
            </a:r>
            <a:r>
              <a:rPr lang="sv-SE" dirty="0" err="1"/>
              <a:t>Dot</a:t>
            </a:r>
            <a:r>
              <a:rPr lang="sv-SE" dirty="0"/>
              <a:t> </a:t>
            </a:r>
            <a:r>
              <a:rPr lang="sv-SE" dirty="0" err="1"/>
              <a:t>plot</a:t>
            </a:r>
            <a:r>
              <a:rPr lang="sv-SE" dirty="0"/>
              <a:t> </a:t>
            </a:r>
            <a:r>
              <a:rPr lang="sv-SE" dirty="0" err="1"/>
              <a:t>representing</a:t>
            </a:r>
            <a:r>
              <a:rPr lang="sv-SE" dirty="0"/>
              <a:t> the </a:t>
            </a:r>
            <a:r>
              <a:rPr lang="sv-SE" dirty="0" err="1"/>
              <a:t>ratio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</a:t>
            </a:r>
            <a:r>
              <a:rPr lang="sv-SE" dirty="0" err="1"/>
              <a:t>counts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human genes </a:t>
            </a:r>
            <a:r>
              <a:rPr lang="sv-SE" dirty="0" err="1"/>
              <a:t>against</a:t>
            </a:r>
            <a:r>
              <a:rPr lang="sv-SE" dirty="0"/>
              <a:t> </a:t>
            </a:r>
            <a:r>
              <a:rPr lang="sv-SE" dirty="0" err="1"/>
              <a:t>mouse</a:t>
            </a:r>
            <a:r>
              <a:rPr lang="sv-SE" dirty="0"/>
              <a:t> genes (</a:t>
            </a:r>
            <a:r>
              <a:rPr lang="sv-SE" dirty="0" err="1"/>
              <a:t>top</a:t>
            </a:r>
            <a:r>
              <a:rPr lang="sv-SE" dirty="0"/>
              <a:t>) and relation </a:t>
            </a:r>
            <a:r>
              <a:rPr lang="sv-SE" dirty="0" err="1"/>
              <a:t>of</a:t>
            </a:r>
            <a:r>
              <a:rPr lang="sv-SE" dirty="0"/>
              <a:t> </a:t>
            </a:r>
            <a:r>
              <a:rPr lang="sv-SE" dirty="0" err="1"/>
              <a:t>mouse</a:t>
            </a:r>
            <a:r>
              <a:rPr lang="sv-SE" dirty="0"/>
              <a:t> transcripts </a:t>
            </a:r>
            <a:r>
              <a:rPr lang="sv-SE" dirty="0" err="1"/>
              <a:t>against</a:t>
            </a:r>
            <a:r>
              <a:rPr lang="sv-SE" dirty="0"/>
              <a:t> human transcripts (</a:t>
            </a:r>
            <a:r>
              <a:rPr lang="sv-SE" dirty="0" err="1"/>
              <a:t>bottom</a:t>
            </a:r>
            <a:r>
              <a:rPr lang="sv-SE" dirty="0"/>
              <a:t>) and </a:t>
            </a:r>
            <a:r>
              <a:rPr lang="sv-SE" dirty="0" err="1"/>
              <a:t>ratio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 from data </a:t>
            </a:r>
            <a:r>
              <a:rPr lang="sv-SE" dirty="0" err="1"/>
              <a:t>extracted</a:t>
            </a:r>
            <a:r>
              <a:rPr lang="sv-SE" dirty="0"/>
              <a:t> from </a:t>
            </a:r>
            <a:r>
              <a:rPr lang="sv-SE" i="1" dirty="0"/>
              <a:t>in </a:t>
            </a:r>
            <a:r>
              <a:rPr lang="sv-SE" i="1" dirty="0" err="1"/>
              <a:t>vivo</a:t>
            </a:r>
            <a:r>
              <a:rPr lang="sv-SE" i="1" dirty="0"/>
              <a:t> </a:t>
            </a:r>
            <a:r>
              <a:rPr lang="sv-SE" dirty="0" err="1"/>
              <a:t>grafted</a:t>
            </a:r>
            <a:r>
              <a:rPr lang="sv-SE" dirty="0"/>
              <a:t> </a:t>
            </a:r>
            <a:r>
              <a:rPr lang="sv-SE" dirty="0" err="1"/>
              <a:t>hIPSC</a:t>
            </a:r>
            <a:r>
              <a:rPr lang="sv-SE" dirty="0"/>
              <a:t> 5 </a:t>
            </a:r>
            <a:r>
              <a:rPr lang="sv-SE" dirty="0" err="1"/>
              <a:t>months</a:t>
            </a:r>
            <a:r>
              <a:rPr lang="sv-SE" dirty="0"/>
              <a:t> post-</a:t>
            </a:r>
            <a:r>
              <a:rPr lang="sv-SE" dirty="0" err="1"/>
              <a:t>graft</a:t>
            </a:r>
            <a:r>
              <a:rPr lang="sv-SE" dirty="0"/>
              <a:t>. </a:t>
            </a:r>
            <a:r>
              <a:rPr lang="sv-SE" b="1" dirty="0"/>
              <a:t>c</a:t>
            </a:r>
            <a:r>
              <a:rPr lang="sv-SE" dirty="0"/>
              <a:t>, </a:t>
            </a:r>
            <a:r>
              <a:rPr lang="sv-SE" dirty="0" err="1"/>
              <a:t>Dot</a:t>
            </a:r>
            <a:r>
              <a:rPr lang="sv-SE" dirty="0"/>
              <a:t> </a:t>
            </a:r>
            <a:r>
              <a:rPr lang="sv-SE" dirty="0" err="1"/>
              <a:t>plot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relation </a:t>
            </a:r>
            <a:r>
              <a:rPr lang="sv-SE" dirty="0" err="1"/>
              <a:t>between</a:t>
            </a:r>
            <a:r>
              <a:rPr lang="sv-SE" dirty="0"/>
              <a:t> human features (</a:t>
            </a:r>
            <a:r>
              <a:rPr lang="sv-SE" dirty="0" err="1"/>
              <a:t>number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human genes </a:t>
            </a:r>
            <a:r>
              <a:rPr lang="sv-SE" dirty="0" err="1"/>
              <a:t>expressed</a:t>
            </a:r>
            <a:r>
              <a:rPr lang="sv-SE" dirty="0"/>
              <a:t> per cell) and human transcripts (UMI per cell).  </a:t>
            </a:r>
            <a:r>
              <a:rPr lang="sv-SE" b="1" dirty="0"/>
              <a:t>d</a:t>
            </a:r>
            <a:r>
              <a:rPr lang="sv-SE" b="0" dirty="0"/>
              <a:t>,</a:t>
            </a:r>
            <a:r>
              <a:rPr lang="sv-SE" dirty="0"/>
              <a:t> Violin </a:t>
            </a:r>
            <a:r>
              <a:rPr lang="sv-SE" dirty="0" err="1"/>
              <a:t>plots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data from </a:t>
            </a:r>
            <a:r>
              <a:rPr lang="sv-SE" i="1" dirty="0"/>
              <a:t>in </a:t>
            </a:r>
            <a:r>
              <a:rPr lang="sv-SE" i="1" dirty="0" err="1"/>
              <a:t>vivo</a:t>
            </a:r>
            <a:r>
              <a:rPr lang="sv-SE" i="1" dirty="0"/>
              <a:t> </a:t>
            </a:r>
            <a:r>
              <a:rPr lang="sv-SE" i="0" dirty="0"/>
              <a:t>(</a:t>
            </a:r>
            <a:r>
              <a:rPr lang="sv-SE" i="0" dirty="0" err="1"/>
              <a:t>grafted</a:t>
            </a:r>
            <a:r>
              <a:rPr lang="sv-SE" i="0" dirty="0"/>
              <a:t>) </a:t>
            </a:r>
            <a:r>
              <a:rPr lang="sv-SE" i="0" dirty="0" err="1"/>
              <a:t>hIPSC</a:t>
            </a:r>
            <a:r>
              <a:rPr lang="sv-SE" i="0" dirty="0"/>
              <a:t> 5 </a:t>
            </a:r>
            <a:r>
              <a:rPr lang="sv-SE" i="0" dirty="0" err="1"/>
              <a:t>months</a:t>
            </a:r>
            <a:r>
              <a:rPr lang="sv-SE" i="0" dirty="0"/>
              <a:t> post-</a:t>
            </a:r>
            <a:r>
              <a:rPr lang="sv-SE" i="0" dirty="0" err="1"/>
              <a:t>graft</a:t>
            </a:r>
            <a:r>
              <a:rPr lang="sv-SE" i="0" dirty="0"/>
              <a:t>. Data </a:t>
            </a:r>
            <a:r>
              <a:rPr lang="sv-SE" i="0" dirty="0" err="1"/>
              <a:t>represented</a:t>
            </a:r>
            <a:r>
              <a:rPr lang="sv-SE" i="0" dirty="0"/>
              <a:t> is </a:t>
            </a:r>
            <a:r>
              <a:rPr lang="sv-SE" dirty="0"/>
              <a:t>RNA </a:t>
            </a:r>
            <a:r>
              <a:rPr lang="sv-SE" dirty="0" err="1"/>
              <a:t>count</a:t>
            </a:r>
            <a:r>
              <a:rPr lang="sv-SE" dirty="0"/>
              <a:t> or UMIs per cell </a:t>
            </a:r>
            <a:r>
              <a:rPr lang="sv-SE" dirty="0" err="1"/>
              <a:t>of</a:t>
            </a:r>
            <a:r>
              <a:rPr lang="sv-SE" dirty="0"/>
              <a:t> human transcripts (</a:t>
            </a:r>
            <a:r>
              <a:rPr lang="sv-SE" dirty="0" err="1"/>
              <a:t>Human_transcripts</a:t>
            </a:r>
            <a:r>
              <a:rPr lang="sv-SE" dirty="0"/>
              <a:t>) and </a:t>
            </a:r>
            <a:r>
              <a:rPr lang="sv-SE" dirty="0" err="1"/>
              <a:t>percentage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</a:t>
            </a:r>
            <a:r>
              <a:rPr lang="sv-SE" dirty="0" err="1"/>
              <a:t>mitochondrial</a:t>
            </a:r>
            <a:r>
              <a:rPr lang="sv-SE" dirty="0"/>
              <a:t> genes </a:t>
            </a:r>
            <a:r>
              <a:rPr lang="sv-SE" dirty="0" err="1"/>
              <a:t>expressed</a:t>
            </a:r>
            <a:r>
              <a:rPr lang="sv-SE" dirty="0"/>
              <a:t> (</a:t>
            </a:r>
            <a:r>
              <a:rPr lang="sv-SE" dirty="0" err="1"/>
              <a:t>percent_mito</a:t>
            </a:r>
            <a:r>
              <a:rPr lang="sv-SE" dirty="0"/>
              <a:t>). For the </a:t>
            </a:r>
            <a:r>
              <a:rPr lang="sv-SE" i="1" dirty="0"/>
              <a:t>in </a:t>
            </a:r>
            <a:r>
              <a:rPr lang="sv-SE" i="1" dirty="0" err="1"/>
              <a:t>vivo</a:t>
            </a:r>
            <a:r>
              <a:rPr lang="sv-SE" i="0" dirty="0"/>
              <a:t> data, the </a:t>
            </a:r>
            <a:r>
              <a:rPr lang="sv-SE" i="0" dirty="0" err="1"/>
              <a:t>identity</a:t>
            </a:r>
            <a:r>
              <a:rPr lang="sv-SE" i="0" dirty="0"/>
              <a:t> </a:t>
            </a:r>
            <a:r>
              <a:rPr lang="sv-SE" i="0" dirty="0" err="1"/>
              <a:t>number</a:t>
            </a:r>
            <a:r>
              <a:rPr lang="sv-SE" i="0" dirty="0"/>
              <a:t> is from the ID </a:t>
            </a:r>
            <a:r>
              <a:rPr lang="sv-SE" i="0" dirty="0" err="1"/>
              <a:t>of</a:t>
            </a:r>
            <a:r>
              <a:rPr lang="sv-SE" i="0" dirty="0"/>
              <a:t> the animal </a:t>
            </a:r>
            <a:r>
              <a:rPr lang="sv-SE" i="0" dirty="0" err="1"/>
              <a:t>grafted</a:t>
            </a:r>
            <a:r>
              <a:rPr lang="sv-SE" i="0" dirty="0"/>
              <a:t>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505337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>
            <a:extLst>
              <a:ext uri="{FF2B5EF4-FFF2-40B4-BE49-F238E27FC236}">
                <a16:creationId xmlns:a16="http://schemas.microsoft.com/office/drawing/2014/main" id="{D5EE20A4-F748-E6B1-7BD7-02E5EEA0E6A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279866" y="2549705"/>
            <a:ext cx="15696268" cy="45210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530D4C4-8735-0E03-2A8B-DB8DC975482D}"/>
              </a:ext>
            </a:extLst>
          </p:cNvPr>
          <p:cNvSpPr txBox="1"/>
          <p:nvPr/>
        </p:nvSpPr>
        <p:spPr>
          <a:xfrm>
            <a:off x="702797" y="7210336"/>
            <a:ext cx="15273337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sv-SE" b="1" dirty="0" err="1"/>
              <a:t>Supplementary</a:t>
            </a:r>
            <a:r>
              <a:rPr lang="sv-SE" b="1" dirty="0"/>
              <a:t> Fig. 3</a:t>
            </a:r>
            <a:r>
              <a:rPr lang="sv-SE" dirty="0"/>
              <a:t>. </a:t>
            </a:r>
            <a:r>
              <a:rPr lang="sv-SE" dirty="0" err="1"/>
              <a:t>Phase</a:t>
            </a:r>
            <a:r>
              <a:rPr lang="sv-SE" dirty="0"/>
              <a:t> </a:t>
            </a:r>
            <a:r>
              <a:rPr lang="sv-SE" dirty="0" err="1"/>
              <a:t>plots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</a:t>
            </a:r>
            <a:r>
              <a:rPr lang="sv-SE" dirty="0" err="1"/>
              <a:t>top</a:t>
            </a:r>
            <a:r>
              <a:rPr lang="sv-SE" dirty="0"/>
              <a:t> 10 </a:t>
            </a:r>
            <a:r>
              <a:rPr lang="sv-SE" dirty="0" err="1"/>
              <a:t>most</a:t>
            </a:r>
            <a:r>
              <a:rPr lang="sv-SE" dirty="0"/>
              <a:t> </a:t>
            </a:r>
            <a:r>
              <a:rPr lang="sv-SE" dirty="0" err="1"/>
              <a:t>dynamic</a:t>
            </a:r>
            <a:r>
              <a:rPr lang="sv-SE" dirty="0"/>
              <a:t> genes for </a:t>
            </a:r>
            <a:r>
              <a:rPr lang="sv-SE" dirty="0" err="1"/>
              <a:t>scVelo</a:t>
            </a:r>
            <a:r>
              <a:rPr lang="sv-SE" dirty="0"/>
              <a:t>. </a:t>
            </a:r>
            <a:r>
              <a:rPr lang="en-US" sz="18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ach plot shows spliced versus </a:t>
            </a:r>
            <a:r>
              <a:rPr lang="en-US" sz="18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pliced</a:t>
            </a:r>
            <a:r>
              <a:rPr lang="en-US" sz="18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ranscript counts per cell representing clusters by color (brown: Immature neuron, orange: DA_ONECUT2, green: DA_SOX6, blue: DA_CALB1) with dynamical model fits overlaid (purple).</a:t>
            </a:r>
            <a:endParaRPr lang="en-GB" sz="18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7651517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77</TotalTime>
  <Words>790</Words>
  <Application>Microsoft Office PowerPoint</Application>
  <PresentationFormat>Custom</PresentationFormat>
  <Paragraphs>18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oberto Garcia Swinburn</dc:creator>
  <cp:lastModifiedBy>Roberto Garcia Swinburn</cp:lastModifiedBy>
  <cp:revision>1</cp:revision>
  <dcterms:created xsi:type="dcterms:W3CDTF">2025-08-04T09:09:14Z</dcterms:created>
  <dcterms:modified xsi:type="dcterms:W3CDTF">2025-10-08T13:05:17Z</dcterms:modified>
</cp:coreProperties>
</file>